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20574000" cy="27432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1D5E7-BBE4-4B72-B200-09C365EC7A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185166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028520" y="15856920"/>
            <a:ext cx="185166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FDBA9-A03A-4788-81AC-B6B62EDFF2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0516680" y="640080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028520" y="1585692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0516680" y="1585692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43904-B5B9-4108-AC74-8FB598AB34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596196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7288920" y="6400800"/>
            <a:ext cx="596196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3549320" y="6400800"/>
            <a:ext cx="596196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028520" y="15856920"/>
            <a:ext cx="596196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7288920" y="15856920"/>
            <a:ext cx="596196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3549320" y="15856920"/>
            <a:ext cx="596196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E8480-BF93-42F6-8DB9-5CDE2582B8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028520" y="6400800"/>
            <a:ext cx="18516600" cy="18103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401"/>
              </a:spcBef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21BCB1-C01C-4161-AD83-1E845979AD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18516600" cy="181036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91F3A-2B0B-470B-AC4E-1875D91071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9036000" cy="181036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0516680" y="6400800"/>
            <a:ext cx="9036000" cy="181036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1CEC3-0C2E-41FA-9762-926AB87AD7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4D37D-B160-4B00-B505-6CEDFE783A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028520" y="1098720"/>
            <a:ext cx="18516600" cy="2119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401"/>
              </a:spcBef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4E583-266A-492E-A394-FD9FE924D2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0516680" y="6400800"/>
            <a:ext cx="9036000" cy="181036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028520" y="1585692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5EDB1-CEAD-44C7-9AC7-0DA6309C82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9036000" cy="181036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0516680" y="640080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0516680" y="1585692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AB0DC-458B-480A-8065-8CE2FA88A5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028520" y="640080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0516680" y="6400800"/>
            <a:ext cx="90360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028520" y="15856920"/>
            <a:ext cx="18516600" cy="86353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F55CD-3AED-4A1B-95FB-A46D923B5E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028520" y="1098720"/>
            <a:ext cx="18516600" cy="4572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13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028520" y="6400800"/>
            <a:ext cx="18516600" cy="181036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marL="1028880" indent="-1028880">
              <a:spcBef>
                <a:spcPts val="2401"/>
              </a:spcBef>
              <a:buClr>
                <a:srgbClr val="000000"/>
              </a:buClr>
              <a:buFont typeface="Arial"/>
              <a:buChar char="•"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 lvl="1" marL="2228760" indent="-857160">
              <a:spcBef>
                <a:spcPts val="2401"/>
              </a:spcBef>
              <a:buClr>
                <a:srgbClr val="000000"/>
              </a:buClr>
              <a:buFont typeface="Arial"/>
              <a:buChar char="–"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 lvl="2" marL="3429000" indent="-685800">
              <a:spcBef>
                <a:spcPts val="2401"/>
              </a:spcBef>
              <a:buClr>
                <a:srgbClr val="000000"/>
              </a:buClr>
              <a:buFont typeface="Arial"/>
              <a:buChar char="•"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 lvl="3" marL="4800600" indent="-685800">
              <a:spcBef>
                <a:spcPts val="2401"/>
              </a:spcBef>
              <a:buClr>
                <a:srgbClr val="000000"/>
              </a:buClr>
              <a:buFont typeface="Arial"/>
              <a:buChar char="–"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 lvl="4" marL="6172200" indent="-685800">
              <a:spcBef>
                <a:spcPts val="2401"/>
              </a:spcBef>
              <a:buClr>
                <a:srgbClr val="000000"/>
              </a:buClr>
              <a:buFont typeface="Arial"/>
              <a:buChar char="»"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 lvl="5" marL="6172200" indent="-685800">
              <a:spcBef>
                <a:spcPts val="2401"/>
              </a:spcBef>
              <a:buClr>
                <a:srgbClr val="000000"/>
              </a:buClr>
              <a:buFont typeface="Arial"/>
              <a:buChar char="»"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 lvl="6" marL="6172200" indent="-685800">
              <a:spcBef>
                <a:spcPts val="2401"/>
              </a:spcBef>
              <a:buClr>
                <a:srgbClr val="000000"/>
              </a:buClr>
              <a:buFont typeface="Arial"/>
              <a:buChar char="»"/>
              <a:tabLst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028520" y="25425000"/>
            <a:ext cx="4800600" cy="14605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  <a:defRPr b="0" lang="en-US" sz="3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fld id="{6F0F50E3-9534-4536-A5E2-A984CD5091F6}" type="datetime">
              <a:rPr b="0" lang="en-US" sz="36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7029360" y="25425000"/>
            <a:ext cx="6515280" cy="14605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4744520" y="25425000"/>
            <a:ext cx="4800600" cy="146052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  <a:defRPr b="0" lang="en-US" sz="3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fld id="{853AAC62-B692-4553-9E18-2E15414C5971}" type="slidenum">
              <a:rPr b="0" lang="en-US" sz="3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42"/>
          <p:cNvSpPr/>
          <p:nvPr/>
        </p:nvSpPr>
        <p:spPr>
          <a:xfrm>
            <a:off x="345600" y="4540320"/>
            <a:ext cx="6026760" cy="106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i="1" lang="en-US" sz="6400" spc="-1" strike="noStrike">
                <a:solidFill>
                  <a:srgbClr val="000000"/>
                </a:solidFill>
                <a:latin typeface="Times New Roman"/>
              </a:rPr>
              <a:t>Accipiter virgatus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42"/>
          <p:cNvSpPr/>
          <p:nvPr/>
        </p:nvSpPr>
        <p:spPr>
          <a:xfrm>
            <a:off x="709200" y="18440280"/>
            <a:ext cx="6208200" cy="106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i="1" lang="en-US" sz="6400" spc="-1" strike="noStrike">
                <a:solidFill>
                  <a:srgbClr val="000000"/>
                </a:solidFill>
                <a:latin typeface="Times New Roman"/>
              </a:rPr>
              <a:t>Cyornis rufigastra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459"/>
          <p:cNvGrpSpPr/>
          <p:nvPr/>
        </p:nvGrpSpPr>
        <p:grpSpPr>
          <a:xfrm>
            <a:off x="229320" y="8217000"/>
            <a:ext cx="10346040" cy="4478400"/>
            <a:chOff x="229320" y="8217000"/>
            <a:chExt cx="10346040" cy="4478400"/>
          </a:xfrm>
        </p:grpSpPr>
        <p:sp>
          <p:nvSpPr>
            <p:cNvPr id="44" name="TextBox 442"/>
            <p:cNvSpPr/>
            <p:nvPr/>
          </p:nvSpPr>
          <p:spPr>
            <a:xfrm>
              <a:off x="348840" y="8217000"/>
              <a:ext cx="4809240" cy="106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6400" spc="-1" strike="noStrike">
                  <a:solidFill>
                    <a:srgbClr val="000000"/>
                  </a:solidFill>
                  <a:latin typeface="Times New Roman"/>
                </a:rPr>
                <a:t>Parus elegans</a:t>
              </a:r>
              <a:endParaRPr b="0" lang="en-US" sz="6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Group 458"/>
            <p:cNvGrpSpPr/>
            <p:nvPr/>
          </p:nvGrpSpPr>
          <p:grpSpPr>
            <a:xfrm>
              <a:off x="229320" y="9615960"/>
              <a:ext cx="10346040" cy="3079440"/>
              <a:chOff x="229320" y="9615960"/>
              <a:chExt cx="10346040" cy="3079440"/>
            </a:xfrm>
          </p:grpSpPr>
          <p:sp>
            <p:nvSpPr>
              <p:cNvPr id="46" name="Straight Connector 8"/>
              <p:cNvSpPr/>
              <p:nvPr/>
            </p:nvSpPr>
            <p:spPr>
              <a:xfrm flipV="1">
                <a:off x="1397880" y="11752200"/>
                <a:ext cx="685800" cy="8650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Straight Connector 9"/>
              <p:cNvSpPr/>
              <p:nvPr/>
            </p:nvSpPr>
            <p:spPr>
              <a:xfrm flipH="1">
                <a:off x="2106360" y="10215720"/>
                <a:ext cx="1440" cy="8254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Straight Connector 10"/>
              <p:cNvSpPr/>
              <p:nvPr/>
            </p:nvSpPr>
            <p:spPr>
              <a:xfrm>
                <a:off x="1369800" y="10659960"/>
                <a:ext cx="506160" cy="244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9" name="Group 1104"/>
              <p:cNvGrpSpPr/>
              <p:nvPr/>
            </p:nvGrpSpPr>
            <p:grpSpPr>
              <a:xfrm>
                <a:off x="1378800" y="9615960"/>
                <a:ext cx="9109080" cy="3079440"/>
                <a:chOff x="1378800" y="9615960"/>
                <a:chExt cx="9109080" cy="3079440"/>
              </a:xfrm>
            </p:grpSpPr>
            <p:grpSp>
              <p:nvGrpSpPr>
                <p:cNvPr id="50" name="Group 441"/>
                <p:cNvGrpSpPr/>
                <p:nvPr/>
              </p:nvGrpSpPr>
              <p:grpSpPr>
                <a:xfrm>
                  <a:off x="1378800" y="9615960"/>
                  <a:ext cx="9109080" cy="3079440"/>
                  <a:chOff x="1378800" y="9615960"/>
                  <a:chExt cx="9109080" cy="3079440"/>
                </a:xfrm>
              </p:grpSpPr>
              <p:sp>
                <p:nvSpPr>
                  <p:cNvPr id="51" name="Straight Connector 39"/>
                  <p:cNvSpPr/>
                  <p:nvPr/>
                </p:nvSpPr>
                <p:spPr>
                  <a:xfrm flipH="1">
                    <a:off x="8794440" y="10496160"/>
                    <a:ext cx="28440" cy="117468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Straight Connector 40"/>
                  <p:cNvSpPr/>
                  <p:nvPr/>
                </p:nvSpPr>
                <p:spPr>
                  <a:xfrm>
                    <a:off x="8745840" y="10643040"/>
                    <a:ext cx="1077840" cy="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Straight Connector 41"/>
                  <p:cNvSpPr/>
                  <p:nvPr/>
                </p:nvSpPr>
                <p:spPr>
                  <a:xfrm>
                    <a:off x="6840360" y="12362040"/>
                    <a:ext cx="355320" cy="144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Straight Connector 42"/>
                  <p:cNvSpPr/>
                  <p:nvPr/>
                </p:nvSpPr>
                <p:spPr>
                  <a:xfrm>
                    <a:off x="7507080" y="11752560"/>
                    <a:ext cx="1076400" cy="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Straight Connector 43"/>
                  <p:cNvSpPr/>
                  <p:nvPr/>
                </p:nvSpPr>
                <p:spPr>
                  <a:xfrm flipH="1">
                    <a:off x="7526160" y="11751120"/>
                    <a:ext cx="1440" cy="31896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Straight Connector 44"/>
                  <p:cNvSpPr/>
                  <p:nvPr/>
                </p:nvSpPr>
                <p:spPr>
                  <a:xfrm>
                    <a:off x="6453000" y="10455480"/>
                    <a:ext cx="1074600" cy="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Straight Connector 45"/>
                  <p:cNvSpPr/>
                  <p:nvPr/>
                </p:nvSpPr>
                <p:spPr>
                  <a:xfrm>
                    <a:off x="4322160" y="10457280"/>
                    <a:ext cx="449280" cy="144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Straight Connector 46"/>
                  <p:cNvSpPr/>
                  <p:nvPr/>
                </p:nvSpPr>
                <p:spPr>
                  <a:xfrm>
                    <a:off x="4635000" y="10458720"/>
                    <a:ext cx="447480" cy="144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Straight Connector 47"/>
                  <p:cNvSpPr/>
                  <p:nvPr/>
                </p:nvSpPr>
                <p:spPr>
                  <a:xfrm flipV="1">
                    <a:off x="1615320" y="10493280"/>
                    <a:ext cx="1147680" cy="86652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Straight Connector 48"/>
                  <p:cNvSpPr/>
                  <p:nvPr/>
                </p:nvSpPr>
                <p:spPr>
                  <a:xfrm flipV="1">
                    <a:off x="2083680" y="11380680"/>
                    <a:ext cx="1440" cy="36036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Straight Connector 49"/>
                  <p:cNvSpPr/>
                  <p:nvPr/>
                </p:nvSpPr>
                <p:spPr>
                  <a:xfrm>
                    <a:off x="2183760" y="11741400"/>
                    <a:ext cx="449280" cy="144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62" name="Group 315"/>
                  <p:cNvGrpSpPr/>
                  <p:nvPr/>
                </p:nvGrpSpPr>
                <p:grpSpPr>
                  <a:xfrm>
                    <a:off x="2476800" y="11390760"/>
                    <a:ext cx="665640" cy="677160"/>
                    <a:chOff x="2476800" y="11390760"/>
                    <a:chExt cx="665640" cy="677160"/>
                  </a:xfrm>
                </p:grpSpPr>
                <p:sp>
                  <p:nvSpPr>
                    <p:cNvPr id="63" name="Oval 109"/>
                    <p:cNvSpPr/>
                    <p:nvPr/>
                  </p:nvSpPr>
                  <p:spPr>
                    <a:xfrm>
                      <a:off x="2476800" y="11399760"/>
                      <a:ext cx="665640" cy="66816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" name="TextBox 110"/>
                    <p:cNvSpPr/>
                    <p:nvPr/>
                  </p:nvSpPr>
                  <p:spPr>
                    <a:xfrm>
                      <a:off x="2599560" y="11390760"/>
                      <a:ext cx="412200" cy="6426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1671480"/>
                          <a:tab algn="l" pos="3343320"/>
                          <a:tab algn="l" pos="5014800"/>
                          <a:tab algn="l" pos="6686640"/>
                          <a:tab algn="l" pos="8358120"/>
                          <a:tab algn="l" pos="10029960"/>
                        </a:tabLst>
                      </a:pPr>
                      <a:r>
                        <a:rPr b="0" lang="en-US" sz="3600" spc="-1" strike="noStrike">
                          <a:solidFill>
                            <a:srgbClr val="d9d9d9"/>
                          </a:solidFill>
                          <a:latin typeface="Calibri"/>
                        </a:rPr>
                        <a:t>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65" name="Oval 51"/>
                  <p:cNvSpPr/>
                  <p:nvPr/>
                </p:nvSpPr>
                <p:spPr>
                  <a:xfrm>
                    <a:off x="2509200" y="10296720"/>
                    <a:ext cx="444240" cy="44424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TextBox 52"/>
                  <p:cNvSpPr/>
                  <p:nvPr/>
                </p:nvSpPr>
                <p:spPr>
                  <a:xfrm>
                    <a:off x="2509920" y="10159200"/>
                    <a:ext cx="412200" cy="6426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671480"/>
                        <a:tab algn="l" pos="3343320"/>
                        <a:tab algn="l" pos="5014800"/>
                        <a:tab algn="l" pos="6686640"/>
                        <a:tab algn="l" pos="8358120"/>
                        <a:tab algn="l" pos="10029960"/>
                      </a:tabLst>
                    </a:pPr>
                    <a:r>
                      <a:rPr b="0" lang="en-US" sz="3600" spc="-1" strike="noStrike">
                        <a:solidFill>
                          <a:srgbClr val="d9d9d9"/>
                        </a:solidFill>
                        <a:latin typeface="Calibri"/>
                      </a:rPr>
                      <a:t>2</a:t>
                    </a:r>
                    <a:endParaRPr b="0" lang="en-US" sz="3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Oval 53"/>
                  <p:cNvSpPr/>
                  <p:nvPr/>
                </p:nvSpPr>
                <p:spPr>
                  <a:xfrm>
                    <a:off x="1938960" y="11597040"/>
                    <a:ext cx="276120" cy="27756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Oval 54"/>
                  <p:cNvSpPr/>
                  <p:nvPr/>
                </p:nvSpPr>
                <p:spPr>
                  <a:xfrm>
                    <a:off x="1378800" y="11319120"/>
                    <a:ext cx="277560" cy="279360"/>
                  </a:xfrm>
                  <a:prstGeom prst="ellipse">
                    <a:avLst/>
                  </a:prstGeom>
                  <a:solidFill>
                    <a:srgbClr val="0000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Straight Connector 55"/>
                  <p:cNvSpPr/>
                  <p:nvPr/>
                </p:nvSpPr>
                <p:spPr>
                  <a:xfrm flipH="1" flipV="1">
                    <a:off x="3142080" y="11746080"/>
                    <a:ext cx="4385160" cy="288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3920" bIns="-4392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Oval 56"/>
                  <p:cNvSpPr/>
                  <p:nvPr/>
                </p:nvSpPr>
                <p:spPr>
                  <a:xfrm>
                    <a:off x="4592160" y="11708280"/>
                    <a:ext cx="64800" cy="64800"/>
                  </a:xfrm>
                  <a:prstGeom prst="ellipse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" bIns="-72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TextBox 334"/>
                  <p:cNvSpPr/>
                  <p:nvPr/>
                </p:nvSpPr>
                <p:spPr>
                  <a:xfrm>
                    <a:off x="5673600" y="11644560"/>
                    <a:ext cx="842760" cy="5205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371600"/>
                        <a:tab algn="l" pos="2743200"/>
                        <a:tab algn="l" pos="4114800"/>
                        <a:tab algn="l" pos="5486400"/>
                        <a:tab algn="l" pos="6858000"/>
                        <a:tab algn="l" pos="8229600"/>
                        <a:tab algn="l" pos="9601200"/>
                      </a:tabLst>
                    </a:pPr>
                    <a:r>
                      <a:rPr b="0" i="1" lang="en-US" sz="28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26</a:t>
                    </a:r>
                    <a:endParaRPr b="0" lang="en-US" sz="2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Straight Connector 58"/>
                  <p:cNvSpPr/>
                  <p:nvPr/>
                </p:nvSpPr>
                <p:spPr>
                  <a:xfrm>
                    <a:off x="4625640" y="10458720"/>
                    <a:ext cx="0" cy="1249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Oval 59"/>
                  <p:cNvSpPr/>
                  <p:nvPr/>
                </p:nvSpPr>
                <p:spPr>
                  <a:xfrm>
                    <a:off x="4592160" y="10425240"/>
                    <a:ext cx="64800" cy="66600"/>
                  </a:xfrm>
                  <a:prstGeom prst="ellipse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60" bIns="36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Oval 60"/>
                  <p:cNvSpPr/>
                  <p:nvPr/>
                </p:nvSpPr>
                <p:spPr>
                  <a:xfrm>
                    <a:off x="4897080" y="9615960"/>
                    <a:ext cx="1555920" cy="155556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" name="TextBox 346"/>
                  <p:cNvSpPr/>
                  <p:nvPr/>
                </p:nvSpPr>
                <p:spPr>
                  <a:xfrm>
                    <a:off x="5451480" y="10081080"/>
                    <a:ext cx="412200" cy="642600"/>
                  </a:xfrm>
                  <a:prstGeom prst="rect">
                    <a:avLst/>
                  </a:prstGeom>
                  <a:solidFill>
                    <a:srgbClr val="ffff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371600"/>
                        <a:tab algn="l" pos="2743200"/>
                        <a:tab algn="l" pos="4114800"/>
                        <a:tab algn="l" pos="5486400"/>
                        <a:tab algn="l" pos="6858000"/>
                        <a:tab algn="l" pos="8229600"/>
                        <a:tab algn="l" pos="9601200"/>
                      </a:tabLst>
                    </a:pPr>
                    <a:r>
                      <a:rPr b="0" lang="en-US" sz="3600" spc="-1" strike="noStrike">
                        <a:solidFill>
                          <a:srgbClr val="000000"/>
                        </a:solidFill>
                        <a:latin typeface="Calibri"/>
                      </a:rPr>
                      <a:t>7</a:t>
                    </a:r>
                    <a:endParaRPr b="0" lang="en-US" sz="3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" name="Oval 62"/>
                  <p:cNvSpPr/>
                  <p:nvPr/>
                </p:nvSpPr>
                <p:spPr>
                  <a:xfrm>
                    <a:off x="4122360" y="10299960"/>
                    <a:ext cx="277560" cy="27936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" name="Oval 63"/>
                  <p:cNvSpPr/>
                  <p:nvPr/>
                </p:nvSpPr>
                <p:spPr>
                  <a:xfrm>
                    <a:off x="7473960" y="10215720"/>
                    <a:ext cx="444240" cy="444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Straight Connector 64"/>
                  <p:cNvSpPr/>
                  <p:nvPr/>
                </p:nvSpPr>
                <p:spPr>
                  <a:xfrm flipH="1">
                    <a:off x="6595920" y="1035396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Straight Connector 65"/>
                  <p:cNvSpPr/>
                  <p:nvPr/>
                </p:nvSpPr>
                <p:spPr>
                  <a:xfrm flipH="1">
                    <a:off x="6716520" y="1035396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Straight Connector 66"/>
                  <p:cNvSpPr/>
                  <p:nvPr/>
                </p:nvSpPr>
                <p:spPr>
                  <a:xfrm>
                    <a:off x="6840360" y="10353960"/>
                    <a:ext cx="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Straight Connector 67"/>
                  <p:cNvSpPr/>
                  <p:nvPr/>
                </p:nvSpPr>
                <p:spPr>
                  <a:xfrm flipH="1">
                    <a:off x="6962760" y="1035072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Straight Connector 68"/>
                  <p:cNvSpPr/>
                  <p:nvPr/>
                </p:nvSpPr>
                <p:spPr>
                  <a:xfrm flipH="1">
                    <a:off x="7088040" y="1035396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Straight Connector 69"/>
                  <p:cNvSpPr/>
                  <p:nvPr/>
                </p:nvSpPr>
                <p:spPr>
                  <a:xfrm>
                    <a:off x="7210440" y="10350720"/>
                    <a:ext cx="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" name="Straight Connector 70"/>
                  <p:cNvSpPr/>
                  <p:nvPr/>
                </p:nvSpPr>
                <p:spPr>
                  <a:xfrm flipH="1">
                    <a:off x="7335720" y="1034748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" name="TextBox 362"/>
                  <p:cNvSpPr/>
                  <p:nvPr/>
                </p:nvSpPr>
                <p:spPr>
                  <a:xfrm>
                    <a:off x="7492320" y="10090800"/>
                    <a:ext cx="412200" cy="6426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371600"/>
                        <a:tab algn="l" pos="2743200"/>
                        <a:tab algn="l" pos="4114800"/>
                        <a:tab algn="l" pos="5486400"/>
                        <a:tab algn="l" pos="6858000"/>
                        <a:tab algn="l" pos="8229600"/>
                        <a:tab algn="l" pos="9601200"/>
                      </a:tabLst>
                    </a:pPr>
                    <a:r>
                      <a:rPr b="0" lang="en-US" sz="3600" spc="-1" strike="noStrike">
                        <a:solidFill>
                          <a:srgbClr val="000000"/>
                        </a:solidFill>
                        <a:latin typeface="Calibri"/>
                      </a:rPr>
                      <a:t>2</a:t>
                    </a:r>
                    <a:endParaRPr b="0" lang="en-US" sz="3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" name="Oval 72"/>
                  <p:cNvSpPr/>
                  <p:nvPr/>
                </p:nvSpPr>
                <p:spPr>
                  <a:xfrm>
                    <a:off x="8583840" y="11528640"/>
                    <a:ext cx="444240" cy="44424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" name="Oval 73"/>
                  <p:cNvSpPr/>
                  <p:nvPr/>
                </p:nvSpPr>
                <p:spPr>
                  <a:xfrm>
                    <a:off x="6740280" y="12217680"/>
                    <a:ext cx="279360" cy="27756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" name="Oval 74"/>
                  <p:cNvSpPr/>
                  <p:nvPr/>
                </p:nvSpPr>
                <p:spPr>
                  <a:xfrm>
                    <a:off x="7196040" y="12028680"/>
                    <a:ext cx="666720" cy="6667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" name="Oval 75"/>
                  <p:cNvSpPr/>
                  <p:nvPr/>
                </p:nvSpPr>
                <p:spPr>
                  <a:xfrm>
                    <a:off x="7496280" y="11716200"/>
                    <a:ext cx="66600" cy="68040"/>
                  </a:xfrm>
                  <a:prstGeom prst="ellipse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00" bIns="1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Straight Connector 76"/>
                  <p:cNvSpPr/>
                  <p:nvPr/>
                </p:nvSpPr>
                <p:spPr>
                  <a:xfrm flipH="1">
                    <a:off x="7705800" y="1165104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Straight Connector 77"/>
                  <p:cNvSpPr/>
                  <p:nvPr/>
                </p:nvSpPr>
                <p:spPr>
                  <a:xfrm flipH="1">
                    <a:off x="7826400" y="11652480"/>
                    <a:ext cx="1440" cy="2124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Straight Connector 78"/>
                  <p:cNvSpPr/>
                  <p:nvPr/>
                </p:nvSpPr>
                <p:spPr>
                  <a:xfrm flipH="1">
                    <a:off x="7948800" y="1164924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Straight Connector 79"/>
                  <p:cNvSpPr/>
                  <p:nvPr/>
                </p:nvSpPr>
                <p:spPr>
                  <a:xfrm flipH="1">
                    <a:off x="8072640" y="1164780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Straight Connector 80"/>
                  <p:cNvSpPr/>
                  <p:nvPr/>
                </p:nvSpPr>
                <p:spPr>
                  <a:xfrm flipH="1">
                    <a:off x="8196480" y="1165104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Straight Connector 81"/>
                  <p:cNvSpPr/>
                  <p:nvPr/>
                </p:nvSpPr>
                <p:spPr>
                  <a:xfrm flipH="1">
                    <a:off x="8320320" y="1164780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Straight Connector 82"/>
                  <p:cNvSpPr/>
                  <p:nvPr/>
                </p:nvSpPr>
                <p:spPr>
                  <a:xfrm flipH="1">
                    <a:off x="8445600" y="1164456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TextBox 379"/>
                  <p:cNvSpPr/>
                  <p:nvPr/>
                </p:nvSpPr>
                <p:spPr>
                  <a:xfrm>
                    <a:off x="8597880" y="11404800"/>
                    <a:ext cx="412200" cy="6426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371600"/>
                        <a:tab algn="l" pos="2743200"/>
                        <a:tab algn="l" pos="4114800"/>
                        <a:tab algn="l" pos="5486400"/>
                        <a:tab algn="l" pos="6858000"/>
                        <a:tab algn="l" pos="8229600"/>
                        <a:tab algn="l" pos="9601200"/>
                      </a:tabLst>
                    </a:pPr>
                    <a:r>
                      <a:rPr b="0" lang="en-US" sz="3600" spc="-1" strike="noStrike">
                        <a:solidFill>
                          <a:srgbClr val="000000"/>
                        </a:solidFill>
                        <a:latin typeface="Calibri"/>
                      </a:rPr>
                      <a:t>2</a:t>
                    </a:r>
                    <a:endParaRPr b="0" lang="en-US" sz="3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TextBox 380"/>
                  <p:cNvSpPr/>
                  <p:nvPr/>
                </p:nvSpPr>
                <p:spPr>
                  <a:xfrm>
                    <a:off x="7318440" y="12019320"/>
                    <a:ext cx="412200" cy="6426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1371600"/>
                        <a:tab algn="l" pos="2743200"/>
                        <a:tab algn="l" pos="4114800"/>
                        <a:tab algn="l" pos="5486400"/>
                        <a:tab algn="l" pos="6858000"/>
                        <a:tab algn="l" pos="8229600"/>
                        <a:tab algn="l" pos="9601200"/>
                      </a:tabLst>
                    </a:pPr>
                    <a:r>
                      <a:rPr b="0" lang="en-US" sz="3600" spc="-1" strike="noStrike">
                        <a:solidFill>
                          <a:srgbClr val="000000"/>
                        </a:solidFill>
                        <a:latin typeface="Calibri"/>
                      </a:rPr>
                      <a:t>3</a:t>
                    </a:r>
                    <a:endParaRPr b="0" lang="en-US" sz="3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Straight Connector 85"/>
                  <p:cNvSpPr/>
                  <p:nvPr/>
                </p:nvSpPr>
                <p:spPr>
                  <a:xfrm>
                    <a:off x="8704440" y="11288880"/>
                    <a:ext cx="201600" cy="144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Straight Connector 86"/>
                  <p:cNvSpPr/>
                  <p:nvPr/>
                </p:nvSpPr>
                <p:spPr>
                  <a:xfrm>
                    <a:off x="8707680" y="11412720"/>
                    <a:ext cx="201600" cy="144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Oval 87"/>
                  <p:cNvSpPr/>
                  <p:nvPr/>
                </p:nvSpPr>
                <p:spPr>
                  <a:xfrm>
                    <a:off x="8683920" y="10496880"/>
                    <a:ext cx="277560" cy="27612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Oval 88"/>
                  <p:cNvSpPr/>
                  <p:nvPr/>
                </p:nvSpPr>
                <p:spPr>
                  <a:xfrm>
                    <a:off x="9720720" y="10503360"/>
                    <a:ext cx="276120" cy="277560"/>
                  </a:xfrm>
                  <a:prstGeom prst="ellipse">
                    <a:avLst/>
                  </a:prstGeom>
                  <a:solidFill>
                    <a:srgbClr val="ff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Straight Connector 89"/>
                  <p:cNvSpPr/>
                  <p:nvPr/>
                </p:nvSpPr>
                <p:spPr>
                  <a:xfrm flipH="1">
                    <a:off x="9018720" y="1053972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Straight Connector 90"/>
                  <p:cNvSpPr/>
                  <p:nvPr/>
                </p:nvSpPr>
                <p:spPr>
                  <a:xfrm flipH="1">
                    <a:off x="9139320" y="1053972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Straight Connector 91"/>
                  <p:cNvSpPr/>
                  <p:nvPr/>
                </p:nvSpPr>
                <p:spPr>
                  <a:xfrm flipH="1">
                    <a:off x="9263160" y="10538280"/>
                    <a:ext cx="1440" cy="2124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Straight Connector 92"/>
                  <p:cNvSpPr/>
                  <p:nvPr/>
                </p:nvSpPr>
                <p:spPr>
                  <a:xfrm flipH="1">
                    <a:off x="9388800" y="10539720"/>
                    <a:ext cx="144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Straight Connector 93"/>
                  <p:cNvSpPr/>
                  <p:nvPr/>
                </p:nvSpPr>
                <p:spPr>
                  <a:xfrm flipH="1">
                    <a:off x="9509400" y="10538280"/>
                    <a:ext cx="1440" cy="2124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Straight Connector 94"/>
                  <p:cNvSpPr/>
                  <p:nvPr/>
                </p:nvSpPr>
                <p:spPr>
                  <a:xfrm>
                    <a:off x="9637920" y="10533240"/>
                    <a:ext cx="0" cy="214200"/>
                  </a:xfrm>
                  <a:prstGeom prst="line">
                    <a:avLst/>
                  </a:prstGeom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5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09" name="Group 439"/>
                  <p:cNvGrpSpPr/>
                  <p:nvPr/>
                </p:nvGrpSpPr>
                <p:grpSpPr>
                  <a:xfrm>
                    <a:off x="8673120" y="10910880"/>
                    <a:ext cx="1814760" cy="289800"/>
                    <a:chOff x="8673120" y="10910880"/>
                    <a:chExt cx="1814760" cy="289800"/>
                  </a:xfrm>
                </p:grpSpPr>
                <p:sp>
                  <p:nvSpPr>
                    <p:cNvPr id="110" name="Straight Connector 96"/>
                    <p:cNvSpPr/>
                    <p:nvPr/>
                  </p:nvSpPr>
                  <p:spPr>
                    <a:xfrm>
                      <a:off x="8853840" y="11041560"/>
                      <a:ext cx="1634040" cy="2052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6280" bIns="-2628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" name="Oval 97"/>
                    <p:cNvSpPr/>
                    <p:nvPr/>
                  </p:nvSpPr>
                  <p:spPr>
                    <a:xfrm>
                      <a:off x="8673120" y="10910880"/>
                      <a:ext cx="277560" cy="27864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" name="Oval 98"/>
                    <p:cNvSpPr/>
                    <p:nvPr/>
                  </p:nvSpPr>
                  <p:spPr>
                    <a:xfrm>
                      <a:off x="10210320" y="10921680"/>
                      <a:ext cx="277560" cy="279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" name="Straight Connector 99"/>
                    <p:cNvSpPr/>
                    <p:nvPr/>
                  </p:nvSpPr>
                  <p:spPr>
                    <a:xfrm flipH="1">
                      <a:off x="9025560" y="10941120"/>
                      <a:ext cx="1440" cy="21348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" name="Straight Connector 100"/>
                    <p:cNvSpPr/>
                    <p:nvPr/>
                  </p:nvSpPr>
                  <p:spPr>
                    <a:xfrm flipH="1">
                      <a:off x="9149400" y="10939320"/>
                      <a:ext cx="1440" cy="21348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" name="Straight Connector 101"/>
                    <p:cNvSpPr/>
                    <p:nvPr/>
                  </p:nvSpPr>
                  <p:spPr>
                    <a:xfrm flipH="1">
                      <a:off x="9271800" y="10937880"/>
                      <a:ext cx="1440" cy="21348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" name="Straight Connector 102"/>
                    <p:cNvSpPr/>
                    <p:nvPr/>
                  </p:nvSpPr>
                  <p:spPr>
                    <a:xfrm flipH="1">
                      <a:off x="9397080" y="10941120"/>
                      <a:ext cx="1440" cy="21348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" name="Straight Connector 103"/>
                    <p:cNvSpPr/>
                    <p:nvPr/>
                  </p:nvSpPr>
                  <p:spPr>
                    <a:xfrm flipH="1">
                      <a:off x="9519480" y="10937880"/>
                      <a:ext cx="1440" cy="21348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8" name="Straight Connector 104"/>
                    <p:cNvSpPr/>
                    <p:nvPr/>
                  </p:nvSpPr>
                  <p:spPr>
                    <a:xfrm flipH="1">
                      <a:off x="9644760" y="10932840"/>
                      <a:ext cx="1440" cy="21672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9" name="Straight Connector 105"/>
                    <p:cNvSpPr/>
                    <p:nvPr/>
                  </p:nvSpPr>
                  <p:spPr>
                    <a:xfrm flipH="1">
                      <a:off x="9763920" y="10942560"/>
                      <a:ext cx="1440" cy="21348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0" name="Straight Connector 106"/>
                    <p:cNvSpPr/>
                    <p:nvPr/>
                  </p:nvSpPr>
                  <p:spPr>
                    <a:xfrm flipH="1">
                      <a:off x="9886320" y="10939320"/>
                      <a:ext cx="1440" cy="21492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1" name="Straight Connector 107"/>
                    <p:cNvSpPr/>
                    <p:nvPr/>
                  </p:nvSpPr>
                  <p:spPr>
                    <a:xfrm>
                      <a:off x="10010160" y="10937880"/>
                      <a:ext cx="0" cy="21492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2" name="Straight Connector 108"/>
                    <p:cNvSpPr/>
                    <p:nvPr/>
                  </p:nvSpPr>
                  <p:spPr>
                    <a:xfrm flipH="1">
                      <a:off x="10134000" y="10941120"/>
                      <a:ext cx="1440" cy="214920"/>
                    </a:xfrm>
                    <a:prstGeom prst="line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5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123" name="TextBox 443"/>
                <p:cNvSpPr/>
                <p:nvPr/>
              </p:nvSpPr>
              <p:spPr>
                <a:xfrm>
                  <a:off x="4111560" y="10810800"/>
                  <a:ext cx="877680" cy="520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371600"/>
                      <a:tab algn="l" pos="2743200"/>
                      <a:tab algn="l" pos="4114800"/>
                      <a:tab algn="l" pos="5486400"/>
                      <a:tab algn="l" pos="6858000"/>
                      <a:tab algn="l" pos="8229600"/>
                      <a:tab algn="l" pos="9601200"/>
                    </a:tabLst>
                  </a:pPr>
                  <a:r>
                    <a:rPr b="0" i="1" lang="en-US" sz="2800" spc="-1" strike="noStrike">
                      <a:solidFill>
                        <a:srgbClr val="000000"/>
                      </a:solidFill>
                      <a:latin typeface="Times New Roman"/>
                    </a:rPr>
                    <a:t>12</a:t>
                  </a:r>
                  <a:endParaRPr b="0" lang="en-US" sz="2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4" name="Oval 12"/>
              <p:cNvSpPr/>
              <p:nvPr/>
            </p:nvSpPr>
            <p:spPr>
              <a:xfrm>
                <a:off x="1865160" y="11541240"/>
                <a:ext cx="444240" cy="444240"/>
              </a:xfrm>
              <a:prstGeom prst="ellipse">
                <a:avLst/>
              </a:prstGeom>
              <a:blipFill rotWithShape="0">
                <a:blip r:embed="rId1"/>
                <a:srcRect/>
                <a:stretch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TextBox 13"/>
              <p:cNvSpPr/>
              <p:nvPr/>
            </p:nvSpPr>
            <p:spPr>
              <a:xfrm>
                <a:off x="1867680" y="1140156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503360"/>
                    <a:tab algn="l" pos="3006720"/>
                    <a:tab algn="l" pos="4510080"/>
                    <a:tab algn="l" pos="6013440"/>
                    <a:tab algn="l" pos="7516800"/>
                    <a:tab algn="l" pos="9020160"/>
                    <a:tab algn="l" pos="10523520"/>
                  </a:tabLst>
                </a:pPr>
                <a:r>
                  <a:rPr b="0" lang="en-US" sz="3600" spc="-1" strike="noStrike">
                    <a:solidFill>
                      <a:srgbClr val="bfbfbf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Oval 14"/>
              <p:cNvSpPr/>
              <p:nvPr/>
            </p:nvSpPr>
            <p:spPr>
              <a:xfrm>
                <a:off x="1638000" y="10525320"/>
                <a:ext cx="888840" cy="887400"/>
              </a:xfrm>
              <a:prstGeom prst="ellipse">
                <a:avLst/>
              </a:prstGeom>
              <a:blipFill rotWithShape="0">
                <a:blip r:embed="rId2"/>
                <a:srcRect/>
                <a:stretch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Oval 15"/>
              <p:cNvSpPr/>
              <p:nvPr/>
            </p:nvSpPr>
            <p:spPr>
              <a:xfrm>
                <a:off x="1136520" y="10425240"/>
                <a:ext cx="444240" cy="444240"/>
              </a:xfrm>
              <a:prstGeom prst="ellipse">
                <a:avLst/>
              </a:prstGeom>
              <a:solidFill>
                <a:srgbClr val="558ed5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TextBox 16"/>
              <p:cNvSpPr/>
              <p:nvPr/>
            </p:nvSpPr>
            <p:spPr>
              <a:xfrm>
                <a:off x="1139040" y="1028736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671480"/>
                    <a:tab algn="l" pos="3343320"/>
                    <a:tab algn="l" pos="5014800"/>
                    <a:tab algn="l" pos="6686640"/>
                    <a:tab algn="l" pos="8358120"/>
                    <a:tab algn="l" pos="1002996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Oval 17"/>
              <p:cNvSpPr/>
              <p:nvPr/>
            </p:nvSpPr>
            <p:spPr>
              <a:xfrm>
                <a:off x="1966680" y="10078920"/>
                <a:ext cx="277560" cy="277560"/>
              </a:xfrm>
              <a:prstGeom prst="ellipse">
                <a:avLst/>
              </a:prstGeom>
              <a:solidFill>
                <a:srgbClr val="558ed5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Straight Connector 18"/>
              <p:cNvSpPr/>
              <p:nvPr/>
            </p:nvSpPr>
            <p:spPr>
              <a:xfrm>
                <a:off x="1484280" y="12327120"/>
                <a:ext cx="182520" cy="133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Straight Connector 19"/>
              <p:cNvSpPr/>
              <p:nvPr/>
            </p:nvSpPr>
            <p:spPr>
              <a:xfrm>
                <a:off x="1547640" y="12257280"/>
                <a:ext cx="182520" cy="133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Straight Connector 20"/>
              <p:cNvSpPr/>
              <p:nvPr/>
            </p:nvSpPr>
            <p:spPr>
              <a:xfrm>
                <a:off x="1595160" y="12187440"/>
                <a:ext cx="183960" cy="1346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Straight Connector 21"/>
              <p:cNvSpPr/>
              <p:nvPr/>
            </p:nvSpPr>
            <p:spPr>
              <a:xfrm>
                <a:off x="1654200" y="12130200"/>
                <a:ext cx="182520" cy="1346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Straight Connector 22"/>
              <p:cNvSpPr/>
              <p:nvPr/>
            </p:nvSpPr>
            <p:spPr>
              <a:xfrm>
                <a:off x="1757160" y="11995560"/>
                <a:ext cx="182520" cy="1346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Straight Connector 23"/>
              <p:cNvSpPr/>
              <p:nvPr/>
            </p:nvSpPr>
            <p:spPr>
              <a:xfrm>
                <a:off x="1807920" y="11928600"/>
                <a:ext cx="183960" cy="1346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Straight Connector 24"/>
              <p:cNvSpPr/>
              <p:nvPr/>
            </p:nvSpPr>
            <p:spPr>
              <a:xfrm>
                <a:off x="1704960" y="12060360"/>
                <a:ext cx="182520" cy="1346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Straight Connector 25"/>
              <p:cNvSpPr/>
              <p:nvPr/>
            </p:nvSpPr>
            <p:spPr>
              <a:xfrm flipH="1">
                <a:off x="3371760" y="1164132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Straight Connector 26"/>
              <p:cNvSpPr/>
              <p:nvPr/>
            </p:nvSpPr>
            <p:spPr>
              <a:xfrm flipH="1">
                <a:off x="3494160" y="11642760"/>
                <a:ext cx="1440" cy="2124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Straight Connector 27"/>
              <p:cNvSpPr/>
              <p:nvPr/>
            </p:nvSpPr>
            <p:spPr>
              <a:xfrm flipH="1">
                <a:off x="3614760" y="1163988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Straight Connector 28"/>
              <p:cNvSpPr/>
              <p:nvPr/>
            </p:nvSpPr>
            <p:spPr>
              <a:xfrm flipH="1">
                <a:off x="3738600" y="1163808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Straight Connector 29"/>
              <p:cNvSpPr/>
              <p:nvPr/>
            </p:nvSpPr>
            <p:spPr>
              <a:xfrm flipH="1">
                <a:off x="3863880" y="1164132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Straight Connector 30"/>
              <p:cNvSpPr/>
              <p:nvPr/>
            </p:nvSpPr>
            <p:spPr>
              <a:xfrm flipH="1">
                <a:off x="3986280" y="1163808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Straight Connector 31"/>
              <p:cNvSpPr/>
              <p:nvPr/>
            </p:nvSpPr>
            <p:spPr>
              <a:xfrm flipH="1">
                <a:off x="4111560" y="1163484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Straight Connector 32"/>
              <p:cNvSpPr/>
              <p:nvPr/>
            </p:nvSpPr>
            <p:spPr>
              <a:xfrm flipH="1">
                <a:off x="4227480" y="1164276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Straight Connector 33"/>
              <p:cNvSpPr/>
              <p:nvPr/>
            </p:nvSpPr>
            <p:spPr>
              <a:xfrm flipH="1">
                <a:off x="4352760" y="1164132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TextBox 34"/>
              <p:cNvSpPr/>
              <p:nvPr/>
            </p:nvSpPr>
            <p:spPr>
              <a:xfrm>
                <a:off x="229320" y="9735120"/>
                <a:ext cx="155088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3600" spc="-1" strike="noStrike">
                    <a:solidFill>
                      <a:srgbClr val="000000"/>
                    </a:solidFill>
                    <a:latin typeface="Times New Roman"/>
                  </a:rPr>
                  <a:t>giliardi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TextBox 455"/>
              <p:cNvSpPr/>
              <p:nvPr/>
            </p:nvSpPr>
            <p:spPr>
              <a:xfrm>
                <a:off x="2403000" y="9615960"/>
                <a:ext cx="228852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3600" spc="-1" strike="noStrike">
                    <a:solidFill>
                      <a:srgbClr val="000000"/>
                    </a:solidFill>
                    <a:latin typeface="Times New Roman"/>
                  </a:rPr>
                  <a:t>montigenus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TextBox 457"/>
              <p:cNvSpPr/>
              <p:nvPr/>
            </p:nvSpPr>
            <p:spPr>
              <a:xfrm>
                <a:off x="8108640" y="12025440"/>
                <a:ext cx="246672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3600" spc="-1" strike="noStrike">
                    <a:solidFill>
                      <a:srgbClr val="000000"/>
                    </a:solidFill>
                    <a:latin typeface="Times New Roman"/>
                  </a:rPr>
                  <a:t>mindanensis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49" name="Group 637"/>
          <p:cNvGrpSpPr/>
          <p:nvPr/>
        </p:nvGrpSpPr>
        <p:grpSpPr>
          <a:xfrm>
            <a:off x="9915120" y="4527720"/>
            <a:ext cx="10636200" cy="5289840"/>
            <a:chOff x="9915120" y="4527720"/>
            <a:chExt cx="10636200" cy="5289840"/>
          </a:xfrm>
        </p:grpSpPr>
        <p:grpSp>
          <p:nvGrpSpPr>
            <p:cNvPr id="150" name="Group 125"/>
            <p:cNvGrpSpPr/>
            <p:nvPr/>
          </p:nvGrpSpPr>
          <p:grpSpPr>
            <a:xfrm>
              <a:off x="10857600" y="5513400"/>
              <a:ext cx="7532640" cy="4304160"/>
              <a:chOff x="10857600" y="5513400"/>
              <a:chExt cx="7532640" cy="4304160"/>
            </a:xfrm>
          </p:grpSpPr>
          <p:sp>
            <p:nvSpPr>
              <p:cNvPr id="151" name="Straight Connector 118"/>
              <p:cNvSpPr/>
              <p:nvPr/>
            </p:nvSpPr>
            <p:spPr>
              <a:xfrm flipH="1">
                <a:off x="15867360" y="8977320"/>
                <a:ext cx="7524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Straight Connector 5"/>
              <p:cNvSpPr/>
              <p:nvPr/>
            </p:nvSpPr>
            <p:spPr>
              <a:xfrm>
                <a:off x="16369200" y="9007560"/>
                <a:ext cx="0" cy="2556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Straight Connector 120"/>
              <p:cNvSpPr/>
              <p:nvPr/>
            </p:nvSpPr>
            <p:spPr>
              <a:xfrm>
                <a:off x="17628480" y="6964200"/>
                <a:ext cx="66672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Straight Connector 121"/>
              <p:cNvSpPr/>
              <p:nvPr/>
            </p:nvSpPr>
            <p:spPr>
              <a:xfrm flipH="1">
                <a:off x="17006040" y="5702040"/>
                <a:ext cx="1440" cy="403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Straight Connector 122"/>
              <p:cNvSpPr/>
              <p:nvPr/>
            </p:nvSpPr>
            <p:spPr>
              <a:xfrm>
                <a:off x="11363040" y="6438960"/>
                <a:ext cx="66672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Straight Connector 9"/>
              <p:cNvSpPr/>
              <p:nvPr/>
            </p:nvSpPr>
            <p:spPr>
              <a:xfrm flipV="1">
                <a:off x="13419000" y="8977320"/>
                <a:ext cx="1673280" cy="79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Straight Connector 124"/>
              <p:cNvSpPr/>
              <p:nvPr/>
            </p:nvSpPr>
            <p:spPr>
              <a:xfrm flipV="1">
                <a:off x="12257640" y="7992720"/>
                <a:ext cx="28440" cy="9874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Straight Connector 125"/>
              <p:cNvSpPr/>
              <p:nvPr/>
            </p:nvSpPr>
            <p:spPr>
              <a:xfrm>
                <a:off x="12371400" y="8977320"/>
                <a:ext cx="95868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Straight Connector 126"/>
              <p:cNvSpPr/>
              <p:nvPr/>
            </p:nvSpPr>
            <p:spPr>
              <a:xfrm flipV="1">
                <a:off x="10857600" y="8959680"/>
                <a:ext cx="1622520" cy="28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Oval 127"/>
              <p:cNvSpPr/>
              <p:nvPr/>
            </p:nvSpPr>
            <p:spPr>
              <a:xfrm>
                <a:off x="10858320" y="8850240"/>
                <a:ext cx="277560" cy="277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Oval 128"/>
              <p:cNvSpPr/>
              <p:nvPr/>
            </p:nvSpPr>
            <p:spPr>
              <a:xfrm>
                <a:off x="12148920" y="7716960"/>
                <a:ext cx="277560" cy="2761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Oval 129"/>
              <p:cNvSpPr/>
              <p:nvPr/>
            </p:nvSpPr>
            <p:spPr>
              <a:xfrm>
                <a:off x="13263480" y="8829720"/>
                <a:ext cx="279360" cy="2761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Oval 130"/>
              <p:cNvSpPr/>
              <p:nvPr/>
            </p:nvSpPr>
            <p:spPr>
              <a:xfrm>
                <a:off x="11490120" y="8131320"/>
                <a:ext cx="1555920" cy="1555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Straight Connector 131"/>
              <p:cNvSpPr/>
              <p:nvPr/>
            </p:nvSpPr>
            <p:spPr>
              <a:xfrm flipH="1">
                <a:off x="11224800" y="886932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Straight Connector 132"/>
              <p:cNvSpPr/>
              <p:nvPr/>
            </p:nvSpPr>
            <p:spPr>
              <a:xfrm flipH="1">
                <a:off x="11363040" y="8871120"/>
                <a:ext cx="1440" cy="222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TextBox 133"/>
              <p:cNvSpPr/>
              <p:nvPr/>
            </p:nvSpPr>
            <p:spPr>
              <a:xfrm>
                <a:off x="12044160" y="859788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503360"/>
                    <a:tab algn="l" pos="3006720"/>
                    <a:tab algn="l" pos="4510080"/>
                    <a:tab algn="l" pos="6013440"/>
                    <a:tab algn="l" pos="7516800"/>
                    <a:tab algn="l" pos="9020160"/>
                    <a:tab algn="l" pos="1052352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7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Straight Connector 134"/>
              <p:cNvSpPr/>
              <p:nvPr/>
            </p:nvSpPr>
            <p:spPr>
              <a:xfrm>
                <a:off x="15092640" y="8319960"/>
                <a:ext cx="0" cy="6667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Oval 135"/>
              <p:cNvSpPr/>
              <p:nvPr/>
            </p:nvSpPr>
            <p:spPr>
              <a:xfrm>
                <a:off x="15056280" y="8940960"/>
                <a:ext cx="666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Oval 136"/>
              <p:cNvSpPr/>
              <p:nvPr/>
            </p:nvSpPr>
            <p:spPr>
              <a:xfrm>
                <a:off x="15059160" y="8288280"/>
                <a:ext cx="666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Straight Connector 137"/>
              <p:cNvSpPr/>
              <p:nvPr/>
            </p:nvSpPr>
            <p:spPr>
              <a:xfrm>
                <a:off x="14989320" y="8539200"/>
                <a:ext cx="2016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Straight Connector 138"/>
              <p:cNvSpPr/>
              <p:nvPr/>
            </p:nvSpPr>
            <p:spPr>
              <a:xfrm>
                <a:off x="14992560" y="8663040"/>
                <a:ext cx="2016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Straight Connector 139"/>
              <p:cNvSpPr/>
              <p:nvPr/>
            </p:nvSpPr>
            <p:spPr>
              <a:xfrm>
                <a:off x="14987880" y="8791560"/>
                <a:ext cx="1998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Straight Connector 140"/>
              <p:cNvSpPr/>
              <p:nvPr/>
            </p:nvSpPr>
            <p:spPr>
              <a:xfrm>
                <a:off x="12029760" y="6438960"/>
                <a:ext cx="3038760" cy="18590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Oval 141"/>
              <p:cNvSpPr/>
              <p:nvPr/>
            </p:nvSpPr>
            <p:spPr>
              <a:xfrm>
                <a:off x="11704320" y="6105240"/>
                <a:ext cx="666720" cy="66672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TextBox 74"/>
              <p:cNvSpPr/>
              <p:nvPr/>
            </p:nvSpPr>
            <p:spPr>
              <a:xfrm>
                <a:off x="13927320" y="8874000"/>
                <a:ext cx="84276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2800" spc="-1" strike="noStrike">
                    <a:solidFill>
                      <a:srgbClr val="000000"/>
                    </a:solidFill>
                    <a:latin typeface="Times New Roman"/>
                  </a:rPr>
                  <a:t>16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TextBox 76"/>
              <p:cNvSpPr/>
              <p:nvPr/>
            </p:nvSpPr>
            <p:spPr>
              <a:xfrm>
                <a:off x="13476240" y="6927840"/>
                <a:ext cx="84132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2800" spc="-1" strike="noStrike">
                    <a:solidFill>
                      <a:srgbClr val="000000"/>
                    </a:solidFill>
                    <a:latin typeface="Times New Roman"/>
                  </a:rPr>
                  <a:t>25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Oval 144"/>
              <p:cNvSpPr/>
              <p:nvPr/>
            </p:nvSpPr>
            <p:spPr>
              <a:xfrm>
                <a:off x="11293200" y="6294240"/>
                <a:ext cx="279360" cy="27936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TextBox 82"/>
              <p:cNvSpPr/>
              <p:nvPr/>
            </p:nvSpPr>
            <p:spPr>
              <a:xfrm>
                <a:off x="11826360" y="610344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Straight Connector 146"/>
              <p:cNvSpPr/>
              <p:nvPr/>
            </p:nvSpPr>
            <p:spPr>
              <a:xfrm flipV="1">
                <a:off x="15116400" y="6964200"/>
                <a:ext cx="1749600" cy="1333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Oval 147"/>
              <p:cNvSpPr/>
              <p:nvPr/>
            </p:nvSpPr>
            <p:spPr>
              <a:xfrm>
                <a:off x="16116840" y="5937120"/>
                <a:ext cx="1778040" cy="17794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Box 89"/>
              <p:cNvSpPr/>
              <p:nvPr/>
            </p:nvSpPr>
            <p:spPr>
              <a:xfrm>
                <a:off x="15251400" y="7389720"/>
                <a:ext cx="84132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28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Oval 35"/>
              <p:cNvSpPr/>
              <p:nvPr/>
            </p:nvSpPr>
            <p:spPr>
              <a:xfrm>
                <a:off x="18112680" y="6818400"/>
                <a:ext cx="277560" cy="2793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Oval 150"/>
              <p:cNvSpPr/>
              <p:nvPr/>
            </p:nvSpPr>
            <p:spPr>
              <a:xfrm>
                <a:off x="16861320" y="5513400"/>
                <a:ext cx="277560" cy="277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Box 98"/>
              <p:cNvSpPr/>
              <p:nvPr/>
            </p:nvSpPr>
            <p:spPr>
              <a:xfrm>
                <a:off x="16794000" y="650988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8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Straight Connector 152"/>
              <p:cNvSpPr/>
              <p:nvPr/>
            </p:nvSpPr>
            <p:spPr>
              <a:xfrm>
                <a:off x="15122880" y="8974080"/>
                <a:ext cx="81288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Oval 153"/>
              <p:cNvSpPr/>
              <p:nvPr/>
            </p:nvSpPr>
            <p:spPr>
              <a:xfrm>
                <a:off x="15723000" y="8756640"/>
                <a:ext cx="444240" cy="44424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Straight Connector 154"/>
              <p:cNvSpPr/>
              <p:nvPr/>
            </p:nvSpPr>
            <p:spPr>
              <a:xfrm flipH="1">
                <a:off x="15345000" y="8864640"/>
                <a:ext cx="1440" cy="2203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Straight Connector 155"/>
              <p:cNvSpPr/>
              <p:nvPr/>
            </p:nvSpPr>
            <p:spPr>
              <a:xfrm flipH="1">
                <a:off x="15483240" y="8866080"/>
                <a:ext cx="1440" cy="222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TextBox 110"/>
              <p:cNvSpPr/>
              <p:nvPr/>
            </p:nvSpPr>
            <p:spPr>
              <a:xfrm>
                <a:off x="15733440" y="8626320"/>
                <a:ext cx="360000" cy="119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2_x0010_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Oval 157"/>
              <p:cNvSpPr/>
              <p:nvPr/>
            </p:nvSpPr>
            <p:spPr>
              <a:xfrm>
                <a:off x="16234200" y="9234720"/>
                <a:ext cx="277560" cy="277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Oval 158"/>
              <p:cNvSpPr/>
              <p:nvPr/>
            </p:nvSpPr>
            <p:spPr>
              <a:xfrm>
                <a:off x="16620120" y="8839080"/>
                <a:ext cx="279360" cy="277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Oval 159"/>
              <p:cNvSpPr/>
              <p:nvPr/>
            </p:nvSpPr>
            <p:spPr>
              <a:xfrm>
                <a:off x="16334280" y="8950320"/>
                <a:ext cx="666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3" name="TextBox 126"/>
            <p:cNvSpPr/>
            <p:nvPr/>
          </p:nvSpPr>
          <p:spPr>
            <a:xfrm>
              <a:off x="10833840" y="4527720"/>
              <a:ext cx="6886440" cy="106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6400" spc="-1" strike="noStrike">
                  <a:solidFill>
                    <a:srgbClr val="000000"/>
                  </a:solidFill>
                  <a:latin typeface="Times New Roman"/>
                </a:rPr>
                <a:t>Phapitreron leucotis</a:t>
              </a:r>
              <a:endParaRPr b="0" lang="en-US" sz="6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Box 462"/>
            <p:cNvSpPr/>
            <p:nvPr/>
          </p:nvSpPr>
          <p:spPr>
            <a:xfrm>
              <a:off x="16508160" y="8956800"/>
              <a:ext cx="38505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brevirostris </a:t>
              </a: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Bohol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TextBox 463"/>
            <p:cNvSpPr/>
            <p:nvPr/>
          </p:nvSpPr>
          <p:spPr>
            <a:xfrm>
              <a:off x="9915120" y="6370920"/>
              <a:ext cx="190908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nigrorum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TextBox 464"/>
            <p:cNvSpPr/>
            <p:nvPr/>
          </p:nvSpPr>
          <p:spPr>
            <a:xfrm>
              <a:off x="15964920" y="7693920"/>
              <a:ext cx="458640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brevirostris </a:t>
              </a: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Mindanao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TextBox 465"/>
            <p:cNvSpPr/>
            <p:nvPr/>
          </p:nvSpPr>
          <p:spPr>
            <a:xfrm>
              <a:off x="9955440" y="7873920"/>
              <a:ext cx="16009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leucoti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8" name="Group 476"/>
          <p:cNvGrpSpPr/>
          <p:nvPr/>
        </p:nvGrpSpPr>
        <p:grpSpPr>
          <a:xfrm>
            <a:off x="814680" y="5611680"/>
            <a:ext cx="6157440" cy="2167920"/>
            <a:chOff x="814680" y="5611680"/>
            <a:chExt cx="6157440" cy="2167920"/>
          </a:xfrm>
        </p:grpSpPr>
        <p:grpSp>
          <p:nvGrpSpPr>
            <p:cNvPr id="199" name="Group 472"/>
            <p:cNvGrpSpPr/>
            <p:nvPr/>
          </p:nvGrpSpPr>
          <p:grpSpPr>
            <a:xfrm>
              <a:off x="2667960" y="5611680"/>
              <a:ext cx="2358720" cy="1586880"/>
              <a:chOff x="2667960" y="5611680"/>
              <a:chExt cx="2358720" cy="1586880"/>
            </a:xfrm>
          </p:grpSpPr>
          <p:sp>
            <p:nvSpPr>
              <p:cNvPr id="200" name="Straight Connector 165"/>
              <p:cNvSpPr/>
              <p:nvPr/>
            </p:nvSpPr>
            <p:spPr>
              <a:xfrm flipV="1">
                <a:off x="3919680" y="6143760"/>
                <a:ext cx="0" cy="776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Oval 166"/>
              <p:cNvSpPr/>
              <p:nvPr/>
            </p:nvSpPr>
            <p:spPr>
              <a:xfrm>
                <a:off x="3781440" y="6920640"/>
                <a:ext cx="276120" cy="27792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Oval 167"/>
              <p:cNvSpPr/>
              <p:nvPr/>
            </p:nvSpPr>
            <p:spPr>
              <a:xfrm>
                <a:off x="3776760" y="5894280"/>
                <a:ext cx="276120" cy="2793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Straight Connector 168"/>
              <p:cNvSpPr/>
              <p:nvPr/>
            </p:nvSpPr>
            <p:spPr>
              <a:xfrm flipV="1">
                <a:off x="2882160" y="5896080"/>
                <a:ext cx="1440" cy="6242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Straight Connector 169"/>
              <p:cNvSpPr/>
              <p:nvPr/>
            </p:nvSpPr>
            <p:spPr>
              <a:xfrm flipH="1">
                <a:off x="2995200" y="6520320"/>
                <a:ext cx="156456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Oval 170"/>
              <p:cNvSpPr/>
              <p:nvPr/>
            </p:nvSpPr>
            <p:spPr>
              <a:xfrm>
                <a:off x="2672640" y="6328080"/>
                <a:ext cx="444600" cy="4446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TextBox 171"/>
              <p:cNvSpPr/>
              <p:nvPr/>
            </p:nvSpPr>
            <p:spPr>
              <a:xfrm>
                <a:off x="2684520" y="620244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671480"/>
                    <a:tab algn="l" pos="3343320"/>
                    <a:tab algn="l" pos="5014800"/>
                    <a:tab algn="l" pos="6686640"/>
                    <a:tab algn="l" pos="8358120"/>
                    <a:tab algn="l" pos="1002996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Straight Connector 172"/>
              <p:cNvSpPr/>
              <p:nvPr/>
            </p:nvSpPr>
            <p:spPr>
              <a:xfrm>
                <a:off x="3271320" y="6413760"/>
                <a:ext cx="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Straight Connector 173"/>
              <p:cNvSpPr/>
              <p:nvPr/>
            </p:nvSpPr>
            <p:spPr>
              <a:xfrm flipH="1">
                <a:off x="3408120" y="641376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Straight Connector 174"/>
              <p:cNvSpPr/>
              <p:nvPr/>
            </p:nvSpPr>
            <p:spPr>
              <a:xfrm flipH="1">
                <a:off x="3544560" y="641232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Oval 175"/>
              <p:cNvSpPr/>
              <p:nvPr/>
            </p:nvSpPr>
            <p:spPr>
              <a:xfrm>
                <a:off x="3706560" y="6328080"/>
                <a:ext cx="444600" cy="4446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TextBox 565"/>
              <p:cNvSpPr/>
              <p:nvPr/>
            </p:nvSpPr>
            <p:spPr>
              <a:xfrm>
                <a:off x="3720960" y="620208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Oval 177"/>
              <p:cNvSpPr/>
              <p:nvPr/>
            </p:nvSpPr>
            <p:spPr>
              <a:xfrm>
                <a:off x="2667960" y="5736960"/>
                <a:ext cx="446040" cy="4446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TextBox 178"/>
              <p:cNvSpPr/>
              <p:nvPr/>
            </p:nvSpPr>
            <p:spPr>
              <a:xfrm>
                <a:off x="2680200" y="561168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671480"/>
                    <a:tab algn="l" pos="3343320"/>
                    <a:tab algn="l" pos="5014800"/>
                    <a:tab algn="l" pos="6686640"/>
                    <a:tab algn="l" pos="8358120"/>
                    <a:tab algn="l" pos="1002996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Straight Connector 179"/>
              <p:cNvSpPr/>
              <p:nvPr/>
            </p:nvSpPr>
            <p:spPr>
              <a:xfrm>
                <a:off x="4601160" y="6512400"/>
                <a:ext cx="33192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Oval 180"/>
              <p:cNvSpPr/>
              <p:nvPr/>
            </p:nvSpPr>
            <p:spPr>
              <a:xfrm>
                <a:off x="4748760" y="6374160"/>
                <a:ext cx="277920" cy="27792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Oval 181"/>
              <p:cNvSpPr/>
              <p:nvPr/>
            </p:nvSpPr>
            <p:spPr>
              <a:xfrm>
                <a:off x="4318200" y="6366240"/>
                <a:ext cx="277920" cy="27792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7" name="TextBox 465"/>
            <p:cNvSpPr/>
            <p:nvPr/>
          </p:nvSpPr>
          <p:spPr>
            <a:xfrm>
              <a:off x="814680" y="6144120"/>
              <a:ext cx="178092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confusu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Luzon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Box 465"/>
            <p:cNvSpPr/>
            <p:nvPr/>
          </p:nvSpPr>
          <p:spPr>
            <a:xfrm>
              <a:off x="5191200" y="6096960"/>
              <a:ext cx="178092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confusu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Panay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Box 464"/>
            <p:cNvSpPr/>
            <p:nvPr/>
          </p:nvSpPr>
          <p:spPr>
            <a:xfrm>
              <a:off x="3152520" y="7137000"/>
              <a:ext cx="15523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quagga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0" name="Group 638"/>
          <p:cNvGrpSpPr/>
          <p:nvPr/>
        </p:nvGrpSpPr>
        <p:grpSpPr>
          <a:xfrm>
            <a:off x="10545120" y="9887040"/>
            <a:ext cx="9306000" cy="4577760"/>
            <a:chOff x="10545120" y="9887040"/>
            <a:chExt cx="9306000" cy="4577760"/>
          </a:xfrm>
        </p:grpSpPr>
        <p:grpSp>
          <p:nvGrpSpPr>
            <p:cNvPr id="221" name="Group 585"/>
            <p:cNvGrpSpPr/>
            <p:nvPr/>
          </p:nvGrpSpPr>
          <p:grpSpPr>
            <a:xfrm>
              <a:off x="11165400" y="11099880"/>
              <a:ext cx="8443800" cy="3354840"/>
              <a:chOff x="11165400" y="11099880"/>
              <a:chExt cx="8443800" cy="3354840"/>
            </a:xfrm>
          </p:grpSpPr>
          <p:sp>
            <p:nvSpPr>
              <p:cNvPr id="222" name="Straight Connector 188"/>
              <p:cNvSpPr/>
              <p:nvPr/>
            </p:nvSpPr>
            <p:spPr>
              <a:xfrm flipV="1">
                <a:off x="18145800" y="11561400"/>
                <a:ext cx="734760" cy="600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Straight Connector 189"/>
              <p:cNvSpPr/>
              <p:nvPr/>
            </p:nvSpPr>
            <p:spPr>
              <a:xfrm flipH="1">
                <a:off x="17556840" y="13249800"/>
                <a:ext cx="58896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Straight Connector 190"/>
              <p:cNvSpPr/>
              <p:nvPr/>
            </p:nvSpPr>
            <p:spPr>
              <a:xfrm flipV="1">
                <a:off x="17532720" y="13263840"/>
                <a:ext cx="0" cy="3204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Straight Connector 191"/>
              <p:cNvSpPr/>
              <p:nvPr/>
            </p:nvSpPr>
            <p:spPr>
              <a:xfrm flipV="1">
                <a:off x="18112320" y="12349440"/>
                <a:ext cx="0" cy="3189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Straight Connector 192"/>
              <p:cNvSpPr/>
              <p:nvPr/>
            </p:nvSpPr>
            <p:spPr>
              <a:xfrm>
                <a:off x="18112320" y="12666960"/>
                <a:ext cx="39204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Straight Connector 193"/>
              <p:cNvSpPr/>
              <p:nvPr/>
            </p:nvSpPr>
            <p:spPr>
              <a:xfrm flipH="1" flipV="1">
                <a:off x="12933360" y="11139480"/>
                <a:ext cx="679320" cy="6444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Straight Connector 194"/>
              <p:cNvSpPr/>
              <p:nvPr/>
            </p:nvSpPr>
            <p:spPr>
              <a:xfrm>
                <a:off x="13835520" y="11668320"/>
                <a:ext cx="10800" cy="9572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Straight Connector 195"/>
              <p:cNvSpPr/>
              <p:nvPr/>
            </p:nvSpPr>
            <p:spPr>
              <a:xfrm flipH="1" flipV="1">
                <a:off x="13485960" y="12662280"/>
                <a:ext cx="180972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Straight Connector 196"/>
              <p:cNvSpPr/>
              <p:nvPr/>
            </p:nvSpPr>
            <p:spPr>
              <a:xfrm flipH="1">
                <a:off x="13524120" y="12277800"/>
                <a:ext cx="176040" cy="357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Straight Connector 197"/>
              <p:cNvSpPr/>
              <p:nvPr/>
            </p:nvSpPr>
            <p:spPr>
              <a:xfrm>
                <a:off x="13467240" y="13600440"/>
                <a:ext cx="76824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Oval 198"/>
              <p:cNvSpPr/>
              <p:nvPr/>
            </p:nvSpPr>
            <p:spPr>
              <a:xfrm>
                <a:off x="14129280" y="13449600"/>
                <a:ext cx="277560" cy="277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Straight Connector 199"/>
              <p:cNvSpPr/>
              <p:nvPr/>
            </p:nvSpPr>
            <p:spPr>
              <a:xfrm>
                <a:off x="13499640" y="13705560"/>
                <a:ext cx="12600" cy="623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Straight Connector 200"/>
              <p:cNvSpPr/>
              <p:nvPr/>
            </p:nvSpPr>
            <p:spPr>
              <a:xfrm>
                <a:off x="13500360" y="12663720"/>
                <a:ext cx="0" cy="6652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Straight Connector 201"/>
              <p:cNvSpPr/>
              <p:nvPr/>
            </p:nvSpPr>
            <p:spPr>
              <a:xfrm flipH="1">
                <a:off x="12755880" y="12658320"/>
                <a:ext cx="744480" cy="4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Oval 202"/>
              <p:cNvSpPr/>
              <p:nvPr/>
            </p:nvSpPr>
            <p:spPr>
              <a:xfrm>
                <a:off x="11165400" y="11673000"/>
                <a:ext cx="1778040" cy="177660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Oval 203"/>
              <p:cNvSpPr/>
              <p:nvPr/>
            </p:nvSpPr>
            <p:spPr>
              <a:xfrm>
                <a:off x="13467240" y="12625560"/>
                <a:ext cx="648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Straight Connector 204"/>
              <p:cNvSpPr/>
              <p:nvPr/>
            </p:nvSpPr>
            <p:spPr>
              <a:xfrm flipH="1">
                <a:off x="13114800" y="1256220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Straight Connector 205"/>
              <p:cNvSpPr/>
              <p:nvPr/>
            </p:nvSpPr>
            <p:spPr>
              <a:xfrm flipH="1">
                <a:off x="13252680" y="12563640"/>
                <a:ext cx="1440" cy="217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Oval 206"/>
              <p:cNvSpPr/>
              <p:nvPr/>
            </p:nvSpPr>
            <p:spPr>
              <a:xfrm>
                <a:off x="13048200" y="13133880"/>
                <a:ext cx="888840" cy="889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Oval 207"/>
              <p:cNvSpPr/>
              <p:nvPr/>
            </p:nvSpPr>
            <p:spPr>
              <a:xfrm>
                <a:off x="13390920" y="11547360"/>
                <a:ext cx="888840" cy="8874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Straight Connector 208"/>
              <p:cNvSpPr/>
              <p:nvPr/>
            </p:nvSpPr>
            <p:spPr>
              <a:xfrm>
                <a:off x="13387680" y="12841560"/>
                <a:ext cx="2016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Straight Connector 209"/>
              <p:cNvSpPr/>
              <p:nvPr/>
            </p:nvSpPr>
            <p:spPr>
              <a:xfrm>
                <a:off x="13390920" y="12965400"/>
                <a:ext cx="20304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Oval 210"/>
              <p:cNvSpPr/>
              <p:nvPr/>
            </p:nvSpPr>
            <p:spPr>
              <a:xfrm>
                <a:off x="13368600" y="14177160"/>
                <a:ext cx="276120" cy="277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TextBox 470"/>
              <p:cNvSpPr/>
              <p:nvPr/>
            </p:nvSpPr>
            <p:spPr>
              <a:xfrm>
                <a:off x="11821680" y="1225404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8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TextBox 212"/>
              <p:cNvSpPr/>
              <p:nvPr/>
            </p:nvSpPr>
            <p:spPr>
              <a:xfrm>
                <a:off x="13600440" y="11668320"/>
                <a:ext cx="42372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503360"/>
                    <a:tab algn="l" pos="3006720"/>
                    <a:tab algn="l" pos="4510080"/>
                    <a:tab algn="l" pos="6013440"/>
                    <a:tab algn="l" pos="7516800"/>
                    <a:tab algn="l" pos="9020160"/>
                    <a:tab algn="l" pos="1052352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4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TextBox 213"/>
              <p:cNvSpPr/>
              <p:nvPr/>
            </p:nvSpPr>
            <p:spPr>
              <a:xfrm>
                <a:off x="13276800" y="13249800"/>
                <a:ext cx="42372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503360"/>
                    <a:tab algn="l" pos="3006720"/>
                    <a:tab algn="l" pos="4510080"/>
                    <a:tab algn="l" pos="6013440"/>
                    <a:tab algn="l" pos="7516800"/>
                    <a:tab algn="l" pos="9020160"/>
                    <a:tab algn="l" pos="1052352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4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Oval 214"/>
              <p:cNvSpPr/>
              <p:nvPr/>
            </p:nvSpPr>
            <p:spPr>
              <a:xfrm>
                <a:off x="13815000" y="12625560"/>
                <a:ext cx="666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Oval 215"/>
              <p:cNvSpPr/>
              <p:nvPr/>
            </p:nvSpPr>
            <p:spPr>
              <a:xfrm>
                <a:off x="12892320" y="11099880"/>
                <a:ext cx="277560" cy="27756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Straight Connector 216"/>
              <p:cNvSpPr/>
              <p:nvPr/>
            </p:nvSpPr>
            <p:spPr>
              <a:xfrm flipH="1">
                <a:off x="13092120" y="11310840"/>
                <a:ext cx="191880" cy="195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Straight Connector 217"/>
              <p:cNvSpPr/>
              <p:nvPr/>
            </p:nvSpPr>
            <p:spPr>
              <a:xfrm flipH="1">
                <a:off x="13181040" y="11377440"/>
                <a:ext cx="191880" cy="195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Straight Connector 218"/>
              <p:cNvSpPr/>
              <p:nvPr/>
            </p:nvSpPr>
            <p:spPr>
              <a:xfrm flipH="1">
                <a:off x="13341240" y="11538000"/>
                <a:ext cx="191880" cy="195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Straight Connector 219"/>
              <p:cNvSpPr/>
              <p:nvPr/>
            </p:nvSpPr>
            <p:spPr>
              <a:xfrm flipH="1">
                <a:off x="13266720" y="11463480"/>
                <a:ext cx="191880" cy="193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Straight Connector 220"/>
              <p:cNvSpPr/>
              <p:nvPr/>
            </p:nvSpPr>
            <p:spPr>
              <a:xfrm>
                <a:off x="15176880" y="12508200"/>
                <a:ext cx="210960" cy="2808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Straight Connector 221"/>
              <p:cNvSpPr/>
              <p:nvPr/>
            </p:nvSpPr>
            <p:spPr>
              <a:xfrm flipH="1" flipV="1">
                <a:off x="15510240" y="12652560"/>
                <a:ext cx="13716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Straight Connector 222"/>
              <p:cNvSpPr/>
              <p:nvPr/>
            </p:nvSpPr>
            <p:spPr>
              <a:xfrm>
                <a:off x="15388200" y="12504960"/>
                <a:ext cx="212400" cy="279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Oval 223"/>
              <p:cNvSpPr/>
              <p:nvPr/>
            </p:nvSpPr>
            <p:spPr>
              <a:xfrm>
                <a:off x="16881840" y="12628800"/>
                <a:ext cx="64800" cy="648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Straight Connector 224"/>
              <p:cNvSpPr/>
              <p:nvPr/>
            </p:nvSpPr>
            <p:spPr>
              <a:xfrm flipH="1" flipV="1">
                <a:off x="16940880" y="12660480"/>
                <a:ext cx="1139760" cy="2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Straight Connector 225"/>
              <p:cNvSpPr/>
              <p:nvPr/>
            </p:nvSpPr>
            <p:spPr>
              <a:xfrm flipH="1">
                <a:off x="17140680" y="1254636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Straight Connector 226"/>
              <p:cNvSpPr/>
              <p:nvPr/>
            </p:nvSpPr>
            <p:spPr>
              <a:xfrm flipH="1">
                <a:off x="17277120" y="1254780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Straight Connector 227"/>
              <p:cNvSpPr/>
              <p:nvPr/>
            </p:nvSpPr>
            <p:spPr>
              <a:xfrm flipH="1">
                <a:off x="17415360" y="1254456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Straight Connector 93"/>
              <p:cNvSpPr/>
              <p:nvPr/>
            </p:nvSpPr>
            <p:spPr>
              <a:xfrm flipH="1">
                <a:off x="17555040" y="1254636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Straight Connector 229"/>
              <p:cNvSpPr/>
              <p:nvPr/>
            </p:nvSpPr>
            <p:spPr>
              <a:xfrm flipH="1">
                <a:off x="17715600" y="12543120"/>
                <a:ext cx="1440" cy="220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Straight Connector 230"/>
              <p:cNvSpPr/>
              <p:nvPr/>
            </p:nvSpPr>
            <p:spPr>
              <a:xfrm flipH="1">
                <a:off x="17855280" y="1254456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Oval 231"/>
              <p:cNvSpPr/>
              <p:nvPr/>
            </p:nvSpPr>
            <p:spPr>
              <a:xfrm>
                <a:off x="18080640" y="12630600"/>
                <a:ext cx="648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TextBox 540"/>
              <p:cNvSpPr/>
              <p:nvPr/>
            </p:nvSpPr>
            <p:spPr>
              <a:xfrm>
                <a:off x="15014880" y="12026880"/>
                <a:ext cx="842760" cy="520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2800" spc="-1" strike="noStrike">
                    <a:solidFill>
                      <a:srgbClr val="000000"/>
                    </a:solidFill>
                    <a:latin typeface="Times New Roman"/>
                  </a:rPr>
                  <a:t>49</a:t>
                </a:r>
                <a:endParaRPr b="0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Straight Connector 233"/>
              <p:cNvSpPr/>
              <p:nvPr/>
            </p:nvSpPr>
            <p:spPr>
              <a:xfrm flipH="1" flipV="1">
                <a:off x="16937640" y="12684240"/>
                <a:ext cx="604800" cy="565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Straight Connector 234"/>
              <p:cNvSpPr/>
              <p:nvPr/>
            </p:nvSpPr>
            <p:spPr>
              <a:xfrm flipH="1">
                <a:off x="17020080" y="12778200"/>
                <a:ext cx="193680" cy="193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Straight Connector 235"/>
              <p:cNvSpPr/>
              <p:nvPr/>
            </p:nvSpPr>
            <p:spPr>
              <a:xfrm flipH="1">
                <a:off x="17110080" y="12843360"/>
                <a:ext cx="190440" cy="195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Straight Connector 236"/>
              <p:cNvSpPr/>
              <p:nvPr/>
            </p:nvSpPr>
            <p:spPr>
              <a:xfrm flipH="1">
                <a:off x="17270640" y="13005000"/>
                <a:ext cx="190440" cy="193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Straight Connector 237"/>
              <p:cNvSpPr/>
              <p:nvPr/>
            </p:nvSpPr>
            <p:spPr>
              <a:xfrm flipH="1">
                <a:off x="17194320" y="12929040"/>
                <a:ext cx="191880" cy="193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Oval 238"/>
              <p:cNvSpPr/>
              <p:nvPr/>
            </p:nvSpPr>
            <p:spPr>
              <a:xfrm>
                <a:off x="17501040" y="13205160"/>
                <a:ext cx="666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Straight Connector 239"/>
              <p:cNvSpPr/>
              <p:nvPr/>
            </p:nvSpPr>
            <p:spPr>
              <a:xfrm flipH="1">
                <a:off x="17732880" y="13147920"/>
                <a:ext cx="1440" cy="2188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Straight Connector 240"/>
              <p:cNvSpPr/>
              <p:nvPr/>
            </p:nvSpPr>
            <p:spPr>
              <a:xfrm flipH="1">
                <a:off x="17871120" y="13147920"/>
                <a:ext cx="1440" cy="220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Oval 241"/>
              <p:cNvSpPr/>
              <p:nvPr/>
            </p:nvSpPr>
            <p:spPr>
              <a:xfrm>
                <a:off x="17396280" y="13491000"/>
                <a:ext cx="276120" cy="27612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Oval 242"/>
              <p:cNvSpPr/>
              <p:nvPr/>
            </p:nvSpPr>
            <p:spPr>
              <a:xfrm>
                <a:off x="18034560" y="13103640"/>
                <a:ext cx="279360" cy="277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Oval 243"/>
              <p:cNvSpPr/>
              <p:nvPr/>
            </p:nvSpPr>
            <p:spPr>
              <a:xfrm>
                <a:off x="18658440" y="11312640"/>
                <a:ext cx="442800" cy="4446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TextBox 565"/>
              <p:cNvSpPr/>
              <p:nvPr/>
            </p:nvSpPr>
            <p:spPr>
              <a:xfrm>
                <a:off x="18672480" y="1118700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Oval 110"/>
              <p:cNvSpPr/>
              <p:nvPr/>
            </p:nvSpPr>
            <p:spPr>
              <a:xfrm>
                <a:off x="17896320" y="11923920"/>
                <a:ext cx="444240" cy="4446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TextBox 567"/>
              <p:cNvSpPr/>
              <p:nvPr/>
            </p:nvSpPr>
            <p:spPr>
              <a:xfrm>
                <a:off x="17910360" y="1179936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Oval 247"/>
              <p:cNvSpPr/>
              <p:nvPr/>
            </p:nvSpPr>
            <p:spPr>
              <a:xfrm>
                <a:off x="18447120" y="12446280"/>
                <a:ext cx="444240" cy="4446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TextBox 569"/>
              <p:cNvSpPr/>
              <p:nvPr/>
            </p:nvSpPr>
            <p:spPr>
              <a:xfrm>
                <a:off x="18461880" y="1232028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Straight Connector 249"/>
              <p:cNvSpPr/>
              <p:nvPr/>
            </p:nvSpPr>
            <p:spPr>
              <a:xfrm>
                <a:off x="18880560" y="12668400"/>
                <a:ext cx="39348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Oval 250"/>
              <p:cNvSpPr/>
              <p:nvPr/>
            </p:nvSpPr>
            <p:spPr>
              <a:xfrm>
                <a:off x="19164960" y="12430440"/>
                <a:ext cx="444240" cy="4446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TextBox 575"/>
              <p:cNvSpPr/>
              <p:nvPr/>
            </p:nvSpPr>
            <p:spPr>
              <a:xfrm>
                <a:off x="19179360" y="1230552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Straight Connector 252"/>
              <p:cNvSpPr/>
              <p:nvPr/>
            </p:nvSpPr>
            <p:spPr>
              <a:xfrm>
                <a:off x="18375120" y="11800080"/>
                <a:ext cx="166680" cy="1936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Straight Connector 253"/>
              <p:cNvSpPr/>
              <p:nvPr/>
            </p:nvSpPr>
            <p:spPr>
              <a:xfrm>
                <a:off x="18493200" y="11685600"/>
                <a:ext cx="164880" cy="195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88" name="TextBox 586"/>
            <p:cNvSpPr/>
            <p:nvPr/>
          </p:nvSpPr>
          <p:spPr>
            <a:xfrm>
              <a:off x="10663200" y="9887040"/>
              <a:ext cx="8128080" cy="106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6400" spc="-1" strike="noStrike">
                  <a:solidFill>
                    <a:srgbClr val="000000"/>
                  </a:solidFill>
                  <a:latin typeface="Times New Roman"/>
                </a:rPr>
                <a:t>Pycnonotus goiavier</a:t>
              </a:r>
              <a:endParaRPr b="0" lang="en-US" sz="6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TextBox 457"/>
            <p:cNvSpPr/>
            <p:nvPr/>
          </p:nvSpPr>
          <p:spPr>
            <a:xfrm>
              <a:off x="17993880" y="13327920"/>
              <a:ext cx="18572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suluensi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TextBox 457"/>
            <p:cNvSpPr/>
            <p:nvPr/>
          </p:nvSpPr>
          <p:spPr>
            <a:xfrm>
              <a:off x="10545120" y="13499280"/>
              <a:ext cx="22395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samarensi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TextBox 457"/>
            <p:cNvSpPr/>
            <p:nvPr/>
          </p:nvSpPr>
          <p:spPr>
            <a:xfrm>
              <a:off x="14033880" y="13822200"/>
              <a:ext cx="170316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goiavier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2" name="Group 636"/>
          <p:cNvGrpSpPr/>
          <p:nvPr/>
        </p:nvGrpSpPr>
        <p:grpSpPr>
          <a:xfrm>
            <a:off x="716040" y="19521360"/>
            <a:ext cx="8156520" cy="2463120"/>
            <a:chOff x="716040" y="19521360"/>
            <a:chExt cx="8156520" cy="2463120"/>
          </a:xfrm>
        </p:grpSpPr>
        <p:grpSp>
          <p:nvGrpSpPr>
            <p:cNvPr id="293" name="Group 632"/>
            <p:cNvGrpSpPr/>
            <p:nvPr/>
          </p:nvGrpSpPr>
          <p:grpSpPr>
            <a:xfrm>
              <a:off x="1492200" y="20166840"/>
              <a:ext cx="3853080" cy="1468080"/>
              <a:chOff x="1492200" y="20166840"/>
              <a:chExt cx="3853080" cy="1468080"/>
            </a:xfrm>
          </p:grpSpPr>
          <p:sp>
            <p:nvSpPr>
              <p:cNvPr id="294" name="Straight Connector 259"/>
              <p:cNvSpPr/>
              <p:nvPr/>
            </p:nvSpPr>
            <p:spPr>
              <a:xfrm flipH="1">
                <a:off x="4843800" y="2086524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Straight Connector 260"/>
              <p:cNvSpPr/>
              <p:nvPr/>
            </p:nvSpPr>
            <p:spPr>
              <a:xfrm flipH="1" flipV="1">
                <a:off x="4441680" y="20982600"/>
                <a:ext cx="6120" cy="5284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Straight Connector 261"/>
              <p:cNvSpPr/>
              <p:nvPr/>
            </p:nvSpPr>
            <p:spPr>
              <a:xfrm>
                <a:off x="4343760" y="21155760"/>
                <a:ext cx="2016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Straight Connector 262"/>
              <p:cNvSpPr/>
              <p:nvPr/>
            </p:nvSpPr>
            <p:spPr>
              <a:xfrm>
                <a:off x="4346640" y="21279600"/>
                <a:ext cx="2016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Straight Connector 263"/>
              <p:cNvSpPr/>
              <p:nvPr/>
            </p:nvSpPr>
            <p:spPr>
              <a:xfrm flipH="1">
                <a:off x="4138920" y="20908080"/>
                <a:ext cx="271440" cy="2030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Straight Connector 264"/>
              <p:cNvSpPr/>
              <p:nvPr/>
            </p:nvSpPr>
            <p:spPr>
              <a:xfrm flipH="1" flipV="1">
                <a:off x="2098080" y="20385720"/>
                <a:ext cx="4680" cy="52848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Oval 265"/>
              <p:cNvSpPr/>
              <p:nvPr/>
            </p:nvSpPr>
            <p:spPr>
              <a:xfrm>
                <a:off x="1957320" y="20193480"/>
                <a:ext cx="279360" cy="2793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Straight Connector 266"/>
              <p:cNvSpPr/>
              <p:nvPr/>
            </p:nvSpPr>
            <p:spPr>
              <a:xfrm>
                <a:off x="1998360" y="20558880"/>
                <a:ext cx="20160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Straight Connector 267"/>
              <p:cNvSpPr/>
              <p:nvPr/>
            </p:nvSpPr>
            <p:spPr>
              <a:xfrm>
                <a:off x="2001600" y="20682720"/>
                <a:ext cx="20160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Straight Connector 268"/>
              <p:cNvSpPr/>
              <p:nvPr/>
            </p:nvSpPr>
            <p:spPr>
              <a:xfrm flipV="1">
                <a:off x="4483440" y="20342880"/>
                <a:ext cx="584280" cy="4759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Straight Connector 269"/>
              <p:cNvSpPr/>
              <p:nvPr/>
            </p:nvSpPr>
            <p:spPr>
              <a:xfrm>
                <a:off x="1492200" y="20831760"/>
                <a:ext cx="3575520" cy="9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Straight Connector 270"/>
              <p:cNvSpPr/>
              <p:nvPr/>
            </p:nvSpPr>
            <p:spPr>
              <a:xfrm>
                <a:off x="2098440" y="20885760"/>
                <a:ext cx="0" cy="3045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Oval 271"/>
              <p:cNvSpPr/>
              <p:nvPr/>
            </p:nvSpPr>
            <p:spPr>
              <a:xfrm>
                <a:off x="4210200" y="20625480"/>
                <a:ext cx="446040" cy="4442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TextBox 272"/>
              <p:cNvSpPr/>
              <p:nvPr/>
            </p:nvSpPr>
            <p:spPr>
              <a:xfrm>
                <a:off x="4224240" y="2049876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671480"/>
                    <a:tab algn="l" pos="3343320"/>
                    <a:tab algn="l" pos="5014800"/>
                    <a:tab algn="l" pos="6686640"/>
                    <a:tab algn="l" pos="8358120"/>
                    <a:tab algn="l" pos="1002996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Oval 273"/>
              <p:cNvSpPr/>
              <p:nvPr/>
            </p:nvSpPr>
            <p:spPr>
              <a:xfrm>
                <a:off x="3770280" y="20692080"/>
                <a:ext cx="277560" cy="277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Oval 274"/>
              <p:cNvSpPr/>
              <p:nvPr/>
            </p:nvSpPr>
            <p:spPr>
              <a:xfrm>
                <a:off x="1966680" y="21085920"/>
                <a:ext cx="276120" cy="2793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Straight Connector 275"/>
              <p:cNvSpPr/>
              <p:nvPr/>
            </p:nvSpPr>
            <p:spPr>
              <a:xfrm flipH="1">
                <a:off x="3351240" y="2073492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Straight Connector 276"/>
              <p:cNvSpPr/>
              <p:nvPr/>
            </p:nvSpPr>
            <p:spPr>
              <a:xfrm flipH="1">
                <a:off x="3487680" y="2073348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Straight Connector 277"/>
              <p:cNvSpPr/>
              <p:nvPr/>
            </p:nvSpPr>
            <p:spPr>
              <a:xfrm flipH="1">
                <a:off x="3625920" y="20731680"/>
                <a:ext cx="1440" cy="2124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Oval 278"/>
              <p:cNvSpPr/>
              <p:nvPr/>
            </p:nvSpPr>
            <p:spPr>
              <a:xfrm>
                <a:off x="2063520" y="20819160"/>
                <a:ext cx="666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Oval 279"/>
              <p:cNvSpPr/>
              <p:nvPr/>
            </p:nvSpPr>
            <p:spPr>
              <a:xfrm>
                <a:off x="4815000" y="20808000"/>
                <a:ext cx="66600" cy="66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Oval 280"/>
              <p:cNvSpPr/>
              <p:nvPr/>
            </p:nvSpPr>
            <p:spPr>
              <a:xfrm>
                <a:off x="4710240" y="21033360"/>
                <a:ext cx="276120" cy="2793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Oval 281"/>
              <p:cNvSpPr/>
              <p:nvPr/>
            </p:nvSpPr>
            <p:spPr>
              <a:xfrm>
                <a:off x="5067720" y="20688840"/>
                <a:ext cx="277560" cy="277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Straight Connector 282"/>
              <p:cNvSpPr/>
              <p:nvPr/>
            </p:nvSpPr>
            <p:spPr>
              <a:xfrm>
                <a:off x="4739040" y="20449080"/>
                <a:ext cx="164880" cy="195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Straight Connector 283"/>
              <p:cNvSpPr/>
              <p:nvPr/>
            </p:nvSpPr>
            <p:spPr>
              <a:xfrm>
                <a:off x="4832640" y="20369880"/>
                <a:ext cx="164880" cy="1951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Oval 284"/>
              <p:cNvSpPr/>
              <p:nvPr/>
            </p:nvSpPr>
            <p:spPr>
              <a:xfrm>
                <a:off x="4972320" y="20166840"/>
                <a:ext cx="277560" cy="27756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Oval 285"/>
              <p:cNvSpPr/>
              <p:nvPr/>
            </p:nvSpPr>
            <p:spPr>
              <a:xfrm>
                <a:off x="2309760" y="20365200"/>
                <a:ext cx="887400" cy="888840"/>
              </a:xfrm>
              <a:prstGeom prst="ellipse">
                <a:avLst/>
              </a:prstGeom>
              <a:blipFill rotWithShape="0">
                <a:blip r:embed="rId3"/>
                <a:srcRect/>
                <a:stretch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TextBox 286"/>
              <p:cNvSpPr/>
              <p:nvPr/>
            </p:nvSpPr>
            <p:spPr>
              <a:xfrm>
                <a:off x="2536920" y="20504880"/>
                <a:ext cx="42228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503360"/>
                    <a:tab algn="l" pos="3006720"/>
                    <a:tab algn="l" pos="4510080"/>
                    <a:tab algn="l" pos="6013440"/>
                    <a:tab algn="l" pos="7516800"/>
                    <a:tab algn="l" pos="9020160"/>
                    <a:tab algn="l" pos="10523520"/>
                  </a:tabLst>
                </a:pPr>
                <a:r>
                  <a:rPr b="0" lang="en-US" sz="3600" spc="-1" strike="noStrike">
                    <a:solidFill>
                      <a:srgbClr val="a6a6a6"/>
                    </a:solidFill>
                    <a:latin typeface="Calibri"/>
                  </a:rPr>
                  <a:t>4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Oval 287"/>
              <p:cNvSpPr/>
              <p:nvPr/>
            </p:nvSpPr>
            <p:spPr>
              <a:xfrm>
                <a:off x="1492200" y="20693880"/>
                <a:ext cx="277560" cy="277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Straight Connector 288"/>
              <p:cNvSpPr/>
              <p:nvPr/>
            </p:nvSpPr>
            <p:spPr>
              <a:xfrm flipH="1">
                <a:off x="1860480" y="2073348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Straight Connector 289"/>
              <p:cNvSpPr/>
              <p:nvPr/>
            </p:nvSpPr>
            <p:spPr>
              <a:xfrm>
                <a:off x="1998360" y="20733480"/>
                <a:ext cx="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Oval 290"/>
              <p:cNvSpPr/>
              <p:nvPr/>
            </p:nvSpPr>
            <p:spPr>
              <a:xfrm>
                <a:off x="3903840" y="21070080"/>
                <a:ext cx="277560" cy="277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Straight Connector 291"/>
              <p:cNvSpPr/>
              <p:nvPr/>
            </p:nvSpPr>
            <p:spPr>
              <a:xfrm>
                <a:off x="4654800" y="20525400"/>
                <a:ext cx="164880" cy="19332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Oval 292"/>
              <p:cNvSpPr/>
              <p:nvPr/>
            </p:nvSpPr>
            <p:spPr>
              <a:xfrm>
                <a:off x="4302360" y="21357360"/>
                <a:ext cx="279360" cy="277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28" name="TextBox 457"/>
            <p:cNvSpPr/>
            <p:nvPr/>
          </p:nvSpPr>
          <p:spPr>
            <a:xfrm>
              <a:off x="716040" y="20889360"/>
              <a:ext cx="12200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blythi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TextBox 457"/>
            <p:cNvSpPr/>
            <p:nvPr/>
          </p:nvSpPr>
          <p:spPr>
            <a:xfrm>
              <a:off x="4966200" y="20793240"/>
              <a:ext cx="274392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philippinensi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Mindanao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TextBox 457"/>
            <p:cNvSpPr/>
            <p:nvPr/>
          </p:nvSpPr>
          <p:spPr>
            <a:xfrm>
              <a:off x="2688120" y="19521360"/>
              <a:ext cx="61844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philippinensis  </a:t>
              </a: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Negros, Panay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1" name="Group 641"/>
          <p:cNvGrpSpPr/>
          <p:nvPr/>
        </p:nvGrpSpPr>
        <p:grpSpPr>
          <a:xfrm>
            <a:off x="244800" y="13584240"/>
            <a:ext cx="10108800" cy="4771080"/>
            <a:chOff x="244800" y="13584240"/>
            <a:chExt cx="10108800" cy="4771080"/>
          </a:xfrm>
        </p:grpSpPr>
        <p:grpSp>
          <p:nvGrpSpPr>
            <p:cNvPr id="332" name="Group 286"/>
            <p:cNvGrpSpPr/>
            <p:nvPr/>
          </p:nvGrpSpPr>
          <p:grpSpPr>
            <a:xfrm>
              <a:off x="539280" y="13584240"/>
              <a:ext cx="9814320" cy="4309560"/>
              <a:chOff x="539280" y="13584240"/>
              <a:chExt cx="9814320" cy="4309560"/>
            </a:xfrm>
          </p:grpSpPr>
          <p:sp>
            <p:nvSpPr>
              <p:cNvPr id="333" name="TextBox 1103"/>
              <p:cNvSpPr/>
              <p:nvPr/>
            </p:nvSpPr>
            <p:spPr>
              <a:xfrm>
                <a:off x="539280" y="13584240"/>
                <a:ext cx="9814320" cy="1069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i="1" lang="en-US" sz="6400" spc="-1" strike="noStrike">
                    <a:solidFill>
                      <a:srgbClr val="000000"/>
                    </a:solidFill>
                    <a:latin typeface="Times New Roman"/>
                  </a:rPr>
                  <a:t>Zosterops montanus</a:t>
                </a:r>
                <a:endParaRPr b="0" lang="en-US" sz="6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34" name="Group 285"/>
              <p:cNvGrpSpPr/>
              <p:nvPr/>
            </p:nvGrpSpPr>
            <p:grpSpPr>
              <a:xfrm>
                <a:off x="1808640" y="14730120"/>
                <a:ext cx="4525920" cy="3163680"/>
                <a:chOff x="1808640" y="14730120"/>
                <a:chExt cx="4525920" cy="3163680"/>
              </a:xfrm>
            </p:grpSpPr>
            <p:sp>
              <p:nvSpPr>
                <p:cNvPr id="335" name="Straight Connector 301"/>
                <p:cNvSpPr/>
                <p:nvPr/>
              </p:nvSpPr>
              <p:spPr>
                <a:xfrm flipH="1" flipV="1">
                  <a:off x="3987720" y="17436600"/>
                  <a:ext cx="347400" cy="33336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Straight Connector 302"/>
                <p:cNvSpPr/>
                <p:nvPr/>
              </p:nvSpPr>
              <p:spPr>
                <a:xfrm flipH="1">
                  <a:off x="3988080" y="17436600"/>
                  <a:ext cx="1936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Straight Connector 303"/>
                <p:cNvSpPr/>
                <p:nvPr/>
              </p:nvSpPr>
              <p:spPr>
                <a:xfrm flipH="1">
                  <a:off x="4057920" y="17505000"/>
                  <a:ext cx="191880" cy="1969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Straight Connector 304"/>
                <p:cNvSpPr/>
                <p:nvPr/>
              </p:nvSpPr>
              <p:spPr>
                <a:xfrm flipV="1">
                  <a:off x="3853440" y="16346520"/>
                  <a:ext cx="1440" cy="7909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Straight Connector 305"/>
                <p:cNvSpPr/>
                <p:nvPr/>
              </p:nvSpPr>
              <p:spPr>
                <a:xfrm>
                  <a:off x="5178960" y="14963400"/>
                  <a:ext cx="0" cy="6638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Straight Connector 253"/>
                <p:cNvSpPr/>
                <p:nvPr/>
              </p:nvSpPr>
              <p:spPr>
                <a:xfrm>
                  <a:off x="5209200" y="15614640"/>
                  <a:ext cx="39204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Straight Connector 307"/>
                <p:cNvSpPr/>
                <p:nvPr/>
              </p:nvSpPr>
              <p:spPr>
                <a:xfrm flipH="1" flipV="1">
                  <a:off x="4375800" y="15314400"/>
                  <a:ext cx="511200" cy="4888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Straight Connector 308"/>
                <p:cNvSpPr/>
                <p:nvPr/>
              </p:nvSpPr>
              <p:spPr>
                <a:xfrm>
                  <a:off x="3988080" y="15312960"/>
                  <a:ext cx="38736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Straight Connector 309"/>
                <p:cNvSpPr/>
                <p:nvPr/>
              </p:nvSpPr>
              <p:spPr>
                <a:xfrm>
                  <a:off x="3993120" y="15064920"/>
                  <a:ext cx="0" cy="9180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000" bIns="450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Straight Connector 310"/>
                <p:cNvSpPr/>
                <p:nvPr/>
              </p:nvSpPr>
              <p:spPr>
                <a:xfrm flipV="1">
                  <a:off x="3091320" y="15187320"/>
                  <a:ext cx="0" cy="31896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Straight Connector 311"/>
                <p:cNvSpPr/>
                <p:nvPr/>
              </p:nvSpPr>
              <p:spPr>
                <a:xfrm flipV="1">
                  <a:off x="3091320" y="15732360"/>
                  <a:ext cx="0" cy="3175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Straight Connector 312"/>
                <p:cNvSpPr/>
                <p:nvPr/>
              </p:nvSpPr>
              <p:spPr>
                <a:xfrm>
                  <a:off x="2287800" y="15613200"/>
                  <a:ext cx="76968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Straight Connector 313"/>
                <p:cNvSpPr/>
                <p:nvPr/>
              </p:nvSpPr>
              <p:spPr>
                <a:xfrm>
                  <a:off x="3819240" y="16312680"/>
                  <a:ext cx="322200" cy="46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Straight Connector 314"/>
                <p:cNvSpPr/>
                <p:nvPr/>
              </p:nvSpPr>
              <p:spPr>
                <a:xfrm flipV="1">
                  <a:off x="4210560" y="15597000"/>
                  <a:ext cx="988920" cy="69876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Straight Connector 315"/>
                <p:cNvSpPr/>
                <p:nvPr/>
              </p:nvSpPr>
              <p:spPr>
                <a:xfrm flipH="1" flipV="1">
                  <a:off x="5882040" y="16380000"/>
                  <a:ext cx="4680" cy="5288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Oval 316"/>
                <p:cNvSpPr/>
                <p:nvPr/>
              </p:nvSpPr>
              <p:spPr>
                <a:xfrm>
                  <a:off x="5445720" y="16793280"/>
                  <a:ext cx="888840" cy="88920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TextBox 317"/>
                <p:cNvSpPr/>
                <p:nvPr/>
              </p:nvSpPr>
              <p:spPr>
                <a:xfrm>
                  <a:off x="5675760" y="16909200"/>
                  <a:ext cx="42372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503360"/>
                      <a:tab algn="l" pos="3006720"/>
                      <a:tab algn="l" pos="4510080"/>
                      <a:tab algn="l" pos="6013440"/>
                      <a:tab algn="l" pos="7516800"/>
                      <a:tab algn="l" pos="9020160"/>
                      <a:tab algn="l" pos="10523520"/>
                    </a:tabLst>
                  </a:pPr>
                  <a:r>
                    <a:rPr b="0" lang="en-US" sz="3600" spc="-1" strike="noStrike">
                      <a:solidFill>
                        <a:srgbClr val="d9d9d9"/>
                      </a:solidFill>
                      <a:latin typeface="Calibri"/>
                    </a:rPr>
                    <a:t>4</a:t>
                  </a:r>
                  <a:endParaRPr b="0" lang="en-US" sz="3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Oval 318"/>
                <p:cNvSpPr/>
                <p:nvPr/>
              </p:nvSpPr>
              <p:spPr>
                <a:xfrm>
                  <a:off x="5742720" y="16189560"/>
                  <a:ext cx="277560" cy="277920"/>
                </a:xfrm>
                <a:prstGeom prst="ellipse">
                  <a:avLst/>
                </a:prstGeom>
                <a:solidFill>
                  <a:srgbClr val="0000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Straight Connector 319"/>
                <p:cNvSpPr/>
                <p:nvPr/>
              </p:nvSpPr>
              <p:spPr>
                <a:xfrm flipH="1" flipV="1">
                  <a:off x="4210200" y="16329600"/>
                  <a:ext cx="15318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Oval 320"/>
                <p:cNvSpPr/>
                <p:nvPr/>
              </p:nvSpPr>
              <p:spPr>
                <a:xfrm>
                  <a:off x="3819960" y="16280280"/>
                  <a:ext cx="66600" cy="66600"/>
                </a:xfrm>
                <a:prstGeom prst="ellipse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" bIns="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Oval 321"/>
                <p:cNvSpPr/>
                <p:nvPr/>
              </p:nvSpPr>
              <p:spPr>
                <a:xfrm>
                  <a:off x="4142160" y="16286400"/>
                  <a:ext cx="68040" cy="64800"/>
                </a:xfrm>
                <a:prstGeom prst="ellipse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Straight Connector 322"/>
                <p:cNvSpPr/>
                <p:nvPr/>
              </p:nvSpPr>
              <p:spPr>
                <a:xfrm flipH="1">
                  <a:off x="3429000" y="17436600"/>
                  <a:ext cx="260280" cy="33336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Oval 323"/>
                <p:cNvSpPr/>
                <p:nvPr/>
              </p:nvSpPr>
              <p:spPr>
                <a:xfrm>
                  <a:off x="5445720" y="15459120"/>
                  <a:ext cx="277560" cy="2779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Oval 324"/>
                <p:cNvSpPr/>
                <p:nvPr/>
              </p:nvSpPr>
              <p:spPr>
                <a:xfrm>
                  <a:off x="3854880" y="15157080"/>
                  <a:ext cx="277560" cy="2779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Oval 325"/>
                <p:cNvSpPr/>
                <p:nvPr/>
              </p:nvSpPr>
              <p:spPr>
                <a:xfrm>
                  <a:off x="4277160" y="15157080"/>
                  <a:ext cx="277560" cy="2779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Oval 326"/>
                <p:cNvSpPr/>
                <p:nvPr/>
              </p:nvSpPr>
              <p:spPr>
                <a:xfrm>
                  <a:off x="4178880" y="17615880"/>
                  <a:ext cx="277560" cy="2779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Oval 327"/>
                <p:cNvSpPr/>
                <p:nvPr/>
              </p:nvSpPr>
              <p:spPr>
                <a:xfrm>
                  <a:off x="3843720" y="14779080"/>
                  <a:ext cx="277560" cy="2761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TextBox 1063"/>
                <p:cNvSpPr/>
                <p:nvPr/>
              </p:nvSpPr>
              <p:spPr>
                <a:xfrm>
                  <a:off x="4575600" y="16215120"/>
                  <a:ext cx="1170000" cy="520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371600"/>
                      <a:tab algn="l" pos="2743200"/>
                      <a:tab algn="l" pos="4114800"/>
                      <a:tab algn="l" pos="5486400"/>
                      <a:tab algn="l" pos="6858000"/>
                      <a:tab algn="l" pos="8229600"/>
                      <a:tab algn="l" pos="9601200"/>
                    </a:tabLst>
                  </a:pPr>
                  <a:r>
                    <a:rPr b="0" i="1" lang="en-US" sz="2800" spc="-1" strike="noStrike">
                      <a:solidFill>
                        <a:srgbClr val="000000"/>
                      </a:solidFill>
                      <a:latin typeface="Times New Roman"/>
                    </a:rPr>
                    <a:t>12</a:t>
                  </a:r>
                  <a:endParaRPr b="0" lang="en-US" sz="2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Straight Connector 329"/>
                <p:cNvSpPr/>
                <p:nvPr/>
              </p:nvSpPr>
              <p:spPr>
                <a:xfrm>
                  <a:off x="5783760" y="1655352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Straight Connector 330"/>
                <p:cNvSpPr/>
                <p:nvPr/>
              </p:nvSpPr>
              <p:spPr>
                <a:xfrm>
                  <a:off x="5785560" y="1667736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Straight Connector 331"/>
                <p:cNvSpPr/>
                <p:nvPr/>
              </p:nvSpPr>
              <p:spPr>
                <a:xfrm flipH="1" flipV="1">
                  <a:off x="3057480" y="15528600"/>
                  <a:ext cx="779400" cy="76716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Oval 332"/>
                <p:cNvSpPr/>
                <p:nvPr/>
              </p:nvSpPr>
              <p:spPr>
                <a:xfrm>
                  <a:off x="2946600" y="15008040"/>
                  <a:ext cx="277560" cy="277920"/>
                </a:xfrm>
                <a:prstGeom prst="ellipse">
                  <a:avLst/>
                </a:prstGeom>
                <a:solidFill>
                  <a:srgbClr val="ffff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Straight Connector 333"/>
                <p:cNvSpPr/>
                <p:nvPr/>
              </p:nvSpPr>
              <p:spPr>
                <a:xfrm flipH="1">
                  <a:off x="3268800" y="15735240"/>
                  <a:ext cx="191880" cy="1969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Straight Connector 334"/>
                <p:cNvSpPr/>
                <p:nvPr/>
              </p:nvSpPr>
              <p:spPr>
                <a:xfrm flipH="1">
                  <a:off x="3429000" y="15895800"/>
                  <a:ext cx="1918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Straight Connector 335"/>
                <p:cNvSpPr/>
                <p:nvPr/>
              </p:nvSpPr>
              <p:spPr>
                <a:xfrm flipH="1">
                  <a:off x="3352680" y="15821280"/>
                  <a:ext cx="1918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Straight Connector 159"/>
                <p:cNvSpPr/>
                <p:nvPr/>
              </p:nvSpPr>
              <p:spPr>
                <a:xfrm flipH="1">
                  <a:off x="3565440" y="16034040"/>
                  <a:ext cx="1918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Straight Connector 337"/>
                <p:cNvSpPr/>
                <p:nvPr/>
              </p:nvSpPr>
              <p:spPr>
                <a:xfrm flipH="1">
                  <a:off x="3643560" y="16100640"/>
                  <a:ext cx="1936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Straight Connector 338"/>
                <p:cNvSpPr/>
                <p:nvPr/>
              </p:nvSpPr>
              <p:spPr>
                <a:xfrm flipH="1">
                  <a:off x="3497400" y="15964200"/>
                  <a:ext cx="191880" cy="1969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Oval 339"/>
                <p:cNvSpPr/>
                <p:nvPr/>
              </p:nvSpPr>
              <p:spPr>
                <a:xfrm>
                  <a:off x="2868840" y="15387480"/>
                  <a:ext cx="444240" cy="444600"/>
                </a:xfrm>
                <a:prstGeom prst="ellipse">
                  <a:avLst/>
                </a:prstGeom>
                <a:solidFill>
                  <a:srgbClr val="ffff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TextBox 1092"/>
                <p:cNvSpPr/>
                <p:nvPr/>
              </p:nvSpPr>
              <p:spPr>
                <a:xfrm>
                  <a:off x="2882160" y="15255000"/>
                  <a:ext cx="41220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371600"/>
                      <a:tab algn="l" pos="2743200"/>
                      <a:tab algn="l" pos="4114800"/>
                      <a:tab algn="l" pos="5486400"/>
                      <a:tab algn="l" pos="6858000"/>
                      <a:tab algn="l" pos="8229600"/>
                      <a:tab algn="l" pos="9601200"/>
                    </a:tabLst>
                  </a:pPr>
                  <a:r>
                    <a:rPr b="0" lang="en-US" sz="36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3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Oval 341"/>
                <p:cNvSpPr/>
                <p:nvPr/>
              </p:nvSpPr>
              <p:spPr>
                <a:xfrm>
                  <a:off x="1808640" y="15138000"/>
                  <a:ext cx="888840" cy="889200"/>
                </a:xfrm>
                <a:prstGeom prst="ellipse">
                  <a:avLst/>
                </a:prstGeom>
                <a:solidFill>
                  <a:srgbClr val="ffff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TextBox 1095"/>
                <p:cNvSpPr/>
                <p:nvPr/>
              </p:nvSpPr>
              <p:spPr>
                <a:xfrm>
                  <a:off x="2037600" y="15253560"/>
                  <a:ext cx="42264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371600"/>
                      <a:tab algn="l" pos="2743200"/>
                      <a:tab algn="l" pos="4114800"/>
                      <a:tab algn="l" pos="5486400"/>
                      <a:tab algn="l" pos="6858000"/>
                      <a:tab algn="l" pos="8229600"/>
                      <a:tab algn="l" pos="9601200"/>
                    </a:tabLst>
                  </a:pPr>
                  <a:r>
                    <a:rPr b="0" lang="en-US" sz="36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3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Oval 343"/>
                <p:cNvSpPr/>
                <p:nvPr/>
              </p:nvSpPr>
              <p:spPr>
                <a:xfrm>
                  <a:off x="2946600" y="15949800"/>
                  <a:ext cx="279360" cy="277920"/>
                </a:xfrm>
                <a:prstGeom prst="ellipse">
                  <a:avLst/>
                </a:prstGeom>
                <a:solidFill>
                  <a:srgbClr val="ffff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Oval 344"/>
                <p:cNvSpPr/>
                <p:nvPr/>
              </p:nvSpPr>
              <p:spPr>
                <a:xfrm>
                  <a:off x="5142600" y="15587640"/>
                  <a:ext cx="66600" cy="64800"/>
                </a:xfrm>
                <a:prstGeom prst="ellipse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Oval 345"/>
                <p:cNvSpPr/>
                <p:nvPr/>
              </p:nvSpPr>
              <p:spPr>
                <a:xfrm>
                  <a:off x="4860000" y="15783120"/>
                  <a:ext cx="68040" cy="64800"/>
                </a:xfrm>
                <a:prstGeom prst="ellipse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Straight Connector 346"/>
                <p:cNvSpPr/>
                <p:nvPr/>
              </p:nvSpPr>
              <p:spPr>
                <a:xfrm flipH="1">
                  <a:off x="4492800" y="15419160"/>
                  <a:ext cx="1918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Straight Connector 347"/>
                <p:cNvSpPr/>
                <p:nvPr/>
              </p:nvSpPr>
              <p:spPr>
                <a:xfrm flipH="1">
                  <a:off x="4629600" y="15555960"/>
                  <a:ext cx="1936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Straight Connector 348"/>
                <p:cNvSpPr/>
                <p:nvPr/>
              </p:nvSpPr>
              <p:spPr>
                <a:xfrm flipH="1">
                  <a:off x="4561200" y="15487560"/>
                  <a:ext cx="193680" cy="1951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Straight Connector 349"/>
                <p:cNvSpPr/>
                <p:nvPr/>
              </p:nvSpPr>
              <p:spPr>
                <a:xfrm>
                  <a:off x="5067720" y="1513980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Straight Connector 350"/>
                <p:cNvSpPr/>
                <p:nvPr/>
              </p:nvSpPr>
              <p:spPr>
                <a:xfrm>
                  <a:off x="5070960" y="1526364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Straight Connector 351"/>
                <p:cNvSpPr/>
                <p:nvPr/>
              </p:nvSpPr>
              <p:spPr>
                <a:xfrm>
                  <a:off x="5070960" y="1538748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Straight Connector 352"/>
                <p:cNvSpPr/>
                <p:nvPr/>
              </p:nvSpPr>
              <p:spPr>
                <a:xfrm>
                  <a:off x="4320000" y="16034040"/>
                  <a:ext cx="172800" cy="2332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Straight Connector 353"/>
                <p:cNvSpPr/>
                <p:nvPr/>
              </p:nvSpPr>
              <p:spPr>
                <a:xfrm>
                  <a:off x="4442400" y="15957720"/>
                  <a:ext cx="172800" cy="2332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Straight Connector 354"/>
                <p:cNvSpPr/>
                <p:nvPr/>
              </p:nvSpPr>
              <p:spPr>
                <a:xfrm>
                  <a:off x="4562280" y="15879960"/>
                  <a:ext cx="174600" cy="2347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Oval 355"/>
                <p:cNvSpPr/>
                <p:nvPr/>
              </p:nvSpPr>
              <p:spPr>
                <a:xfrm>
                  <a:off x="5040720" y="14730120"/>
                  <a:ext cx="276120" cy="2779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Straight Connector 356"/>
                <p:cNvSpPr/>
                <p:nvPr/>
              </p:nvSpPr>
              <p:spPr>
                <a:xfrm>
                  <a:off x="3756600" y="1694088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Straight Connector 357"/>
                <p:cNvSpPr/>
                <p:nvPr/>
              </p:nvSpPr>
              <p:spPr>
                <a:xfrm>
                  <a:off x="3761280" y="16518600"/>
                  <a:ext cx="20160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Straight Connector 358"/>
                <p:cNvSpPr/>
                <p:nvPr/>
              </p:nvSpPr>
              <p:spPr>
                <a:xfrm>
                  <a:off x="3758040" y="1662156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Straight Connector 359"/>
                <p:cNvSpPr/>
                <p:nvPr/>
              </p:nvSpPr>
              <p:spPr>
                <a:xfrm>
                  <a:off x="3761280" y="1673136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Straight Connector 360"/>
                <p:cNvSpPr/>
                <p:nvPr/>
              </p:nvSpPr>
              <p:spPr>
                <a:xfrm>
                  <a:off x="3761280" y="16837560"/>
                  <a:ext cx="20160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Oval 361"/>
                <p:cNvSpPr/>
                <p:nvPr/>
              </p:nvSpPr>
              <p:spPr>
                <a:xfrm>
                  <a:off x="3627720" y="17090280"/>
                  <a:ext cx="444240" cy="44460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TextBox 565"/>
                <p:cNvSpPr/>
                <p:nvPr/>
              </p:nvSpPr>
              <p:spPr>
                <a:xfrm>
                  <a:off x="3641400" y="16965720"/>
                  <a:ext cx="41220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1371600"/>
                      <a:tab algn="l" pos="2743200"/>
                      <a:tab algn="l" pos="4114800"/>
                      <a:tab algn="l" pos="5486400"/>
                      <a:tab algn="l" pos="6858000"/>
                      <a:tab algn="l" pos="8229600"/>
                      <a:tab algn="l" pos="9601200"/>
                    </a:tabLst>
                  </a:pPr>
                  <a:r>
                    <a:rPr b="0" lang="en-US" sz="36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3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Oval 363"/>
                <p:cNvSpPr/>
                <p:nvPr/>
              </p:nvSpPr>
              <p:spPr>
                <a:xfrm>
                  <a:off x="3343680" y="17541360"/>
                  <a:ext cx="277560" cy="276120"/>
                </a:xfrm>
                <a:prstGeom prst="ellipse">
                  <a:avLst/>
                </a:prstGeom>
                <a:solidFill>
                  <a:srgbClr val="ff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398" name="TextBox 460"/>
            <p:cNvSpPr/>
            <p:nvPr/>
          </p:nvSpPr>
          <p:spPr>
            <a:xfrm>
              <a:off x="5894640" y="14439960"/>
              <a:ext cx="394056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vulcani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Mt. Apo, Mt. Busa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TextBox 461"/>
            <p:cNvSpPr/>
            <p:nvPr/>
          </p:nvSpPr>
          <p:spPr>
            <a:xfrm>
              <a:off x="1743120" y="17164080"/>
              <a:ext cx="244080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vulcani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Mt. Pasian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TextBox 457"/>
            <p:cNvSpPr/>
            <p:nvPr/>
          </p:nvSpPr>
          <p:spPr>
            <a:xfrm>
              <a:off x="5467320" y="17577360"/>
              <a:ext cx="21848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whiteheadi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TextBox 457"/>
            <p:cNvSpPr/>
            <p:nvPr/>
          </p:nvSpPr>
          <p:spPr>
            <a:xfrm>
              <a:off x="244800" y="15821640"/>
              <a:ext cx="20080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pectorali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02" name="TextBox 364"/>
          <p:cNvSpPr/>
          <p:nvPr/>
        </p:nvSpPr>
        <p:spPr>
          <a:xfrm>
            <a:off x="1827360" y="10647360"/>
            <a:ext cx="423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503360"/>
                <a:tab algn="l" pos="3006720"/>
                <a:tab algn="l" pos="4510080"/>
                <a:tab algn="l" pos="6013440"/>
                <a:tab algn="l" pos="7516800"/>
                <a:tab algn="l" pos="9020160"/>
                <a:tab algn="l" pos="10523520"/>
              </a:tabLst>
            </a:pPr>
            <a:r>
              <a:rPr b="0" lang="en-US" sz="3600" spc="-1" strike="noStrike">
                <a:solidFill>
                  <a:srgbClr val="d9d9d9"/>
                </a:solidFill>
                <a:latin typeface="Calibri"/>
              </a:rPr>
              <a:t>4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3" name="Group 582"/>
          <p:cNvGrpSpPr/>
          <p:nvPr/>
        </p:nvGrpSpPr>
        <p:grpSpPr>
          <a:xfrm>
            <a:off x="11058480" y="18565920"/>
            <a:ext cx="9815400" cy="2576520"/>
            <a:chOff x="11058480" y="18565920"/>
            <a:chExt cx="9815400" cy="2576520"/>
          </a:xfrm>
        </p:grpSpPr>
        <p:grpSp>
          <p:nvGrpSpPr>
            <p:cNvPr id="404" name="Group 402"/>
            <p:cNvGrpSpPr/>
            <p:nvPr/>
          </p:nvGrpSpPr>
          <p:grpSpPr>
            <a:xfrm>
              <a:off x="13402800" y="19832760"/>
              <a:ext cx="1422720" cy="666720"/>
              <a:chOff x="13402800" y="19832760"/>
              <a:chExt cx="1422720" cy="666720"/>
            </a:xfrm>
          </p:grpSpPr>
          <p:sp>
            <p:nvSpPr>
              <p:cNvPr id="405" name="Straight Connector 371"/>
              <p:cNvSpPr/>
              <p:nvPr/>
            </p:nvSpPr>
            <p:spPr>
              <a:xfrm>
                <a:off x="13934520" y="20194560"/>
                <a:ext cx="44928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Oval 367"/>
              <p:cNvSpPr/>
              <p:nvPr/>
            </p:nvSpPr>
            <p:spPr>
              <a:xfrm>
                <a:off x="13402800" y="19832760"/>
                <a:ext cx="665280" cy="6667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Pie 373"/>
              <p:cNvSpPr/>
              <p:nvPr/>
            </p:nvSpPr>
            <p:spPr>
              <a:xfrm>
                <a:off x="13408920" y="19832760"/>
                <a:ext cx="642960" cy="666720"/>
              </a:xfrm>
              <a:custGeom>
                <a:avLst/>
                <a:gdLst/>
                <a:ahLst/>
                <a:rect l="l" t="t" r="r" b="b"/>
                <a:pathLst>
                  <a:path w="714341" h="741116">
                    <a:moveTo>
                      <a:pt x="145881" y="669323"/>
                    </a:moveTo>
                    <a:cubicBezTo>
                      <a:pt x="49092" y="595646"/>
                      <a:pt x="-5548" y="476451"/>
                      <a:pt x="444" y="352060"/>
                    </a:cubicBezTo>
                    <a:cubicBezTo>
                      <a:pt x="6470" y="226970"/>
                      <a:pt x="72994" y="113503"/>
                      <a:pt x="177287" y="50425"/>
                    </a:cubicBezTo>
                    <a:lnTo>
                      <a:pt x="357171" y="370558"/>
                    </a:lnTo>
                    <a:lnTo>
                      <a:pt x="145881" y="669323"/>
                    </a:lnTo>
                    <a:close/>
                  </a:path>
                </a:pathLst>
              </a:custGeom>
              <a:solidFill>
                <a:srgbClr val="16ce24"/>
              </a:solidFill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TextBox 374"/>
              <p:cNvSpPr/>
              <p:nvPr/>
            </p:nvSpPr>
            <p:spPr>
              <a:xfrm>
                <a:off x="13542840" y="1984392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671480"/>
                    <a:tab algn="l" pos="3343320"/>
                    <a:tab algn="l" pos="5014800"/>
                    <a:tab algn="l" pos="6686640"/>
                    <a:tab algn="l" pos="8358120"/>
                    <a:tab algn="l" pos="10029960"/>
                  </a:tabLst>
                </a:pPr>
                <a:r>
                  <a:rPr b="0" lang="en-US" sz="3600" spc="-1" strike="noStrike">
                    <a:solidFill>
                      <a:srgbClr val="d9d9d9"/>
                    </a:solidFill>
                    <a:latin typeface="Calibri"/>
                  </a:rPr>
                  <a:t>3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Oval 375"/>
              <p:cNvSpPr/>
              <p:nvPr/>
            </p:nvSpPr>
            <p:spPr>
              <a:xfrm>
                <a:off x="14380920" y="19967760"/>
                <a:ext cx="444600" cy="4446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TextBox 379"/>
              <p:cNvSpPr/>
              <p:nvPr/>
            </p:nvSpPr>
            <p:spPr>
              <a:xfrm>
                <a:off x="14394960" y="19843920"/>
                <a:ext cx="4122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371600"/>
                    <a:tab algn="l" pos="2743200"/>
                    <a:tab algn="l" pos="4114800"/>
                    <a:tab algn="l" pos="5486400"/>
                    <a:tab algn="l" pos="6858000"/>
                    <a:tab algn="l" pos="8229600"/>
                    <a:tab algn="l" pos="9601200"/>
                  </a:tabLst>
                </a:pPr>
                <a:r>
                  <a:rPr b="0" lang="en-US" sz="3600" spc="-1" strike="noStrike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Straight Connector 377"/>
              <p:cNvSpPr/>
              <p:nvPr/>
            </p:nvSpPr>
            <p:spPr>
              <a:xfrm flipH="1">
                <a:off x="14133240" y="2008836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Straight Connector 378"/>
              <p:cNvSpPr/>
              <p:nvPr/>
            </p:nvSpPr>
            <p:spPr>
              <a:xfrm flipH="1">
                <a:off x="14269680" y="20088360"/>
                <a:ext cx="1440" cy="21420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13" name="TextBox 455"/>
            <p:cNvSpPr/>
            <p:nvPr/>
          </p:nvSpPr>
          <p:spPr>
            <a:xfrm>
              <a:off x="12808080" y="20499840"/>
              <a:ext cx="17794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manuelli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TextBox 456"/>
            <p:cNvSpPr/>
            <p:nvPr/>
          </p:nvSpPr>
          <p:spPr>
            <a:xfrm>
              <a:off x="11449080" y="19645560"/>
              <a:ext cx="33901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palawana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TextBox 457"/>
            <p:cNvSpPr/>
            <p:nvPr/>
          </p:nvSpPr>
          <p:spPr>
            <a:xfrm>
              <a:off x="14873040" y="19968840"/>
              <a:ext cx="15494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everetti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TextBox 1103"/>
            <p:cNvSpPr/>
            <p:nvPr/>
          </p:nvSpPr>
          <p:spPr>
            <a:xfrm>
              <a:off x="11058480" y="18565920"/>
              <a:ext cx="9815400" cy="106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6400" spc="-1" strike="noStrike">
                  <a:solidFill>
                    <a:srgbClr val="000000"/>
                  </a:solidFill>
                  <a:latin typeface="Times New Roman"/>
                </a:rPr>
                <a:t>Lonchura leucogastra</a:t>
              </a:r>
              <a:endParaRPr b="0" lang="en-US" sz="6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17" name="Group 633"/>
          <p:cNvGrpSpPr/>
          <p:nvPr/>
        </p:nvGrpSpPr>
        <p:grpSpPr>
          <a:xfrm>
            <a:off x="10933200" y="14847840"/>
            <a:ext cx="9815400" cy="3217320"/>
            <a:chOff x="10933200" y="14847840"/>
            <a:chExt cx="9815400" cy="3217320"/>
          </a:xfrm>
        </p:grpSpPr>
        <p:sp>
          <p:nvSpPr>
            <p:cNvPr id="418" name="Straight Connector 380"/>
            <p:cNvSpPr/>
            <p:nvPr/>
          </p:nvSpPr>
          <p:spPr>
            <a:xfrm>
              <a:off x="13763520" y="16852680"/>
              <a:ext cx="0" cy="2919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Straight Connector 381"/>
            <p:cNvSpPr/>
            <p:nvPr/>
          </p:nvSpPr>
          <p:spPr>
            <a:xfrm>
              <a:off x="14319360" y="16730640"/>
              <a:ext cx="0" cy="1807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Straight Connector 382"/>
            <p:cNvSpPr/>
            <p:nvPr/>
          </p:nvSpPr>
          <p:spPr>
            <a:xfrm flipV="1">
              <a:off x="12926880" y="16898400"/>
              <a:ext cx="1577880" cy="126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Oval 383"/>
            <p:cNvSpPr/>
            <p:nvPr/>
          </p:nvSpPr>
          <p:spPr>
            <a:xfrm>
              <a:off x="14181120" y="16452720"/>
              <a:ext cx="276120" cy="2775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Oval 384"/>
            <p:cNvSpPr/>
            <p:nvPr/>
          </p:nvSpPr>
          <p:spPr>
            <a:xfrm>
              <a:off x="14505120" y="16760880"/>
              <a:ext cx="279360" cy="27756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Straight Connector 385"/>
            <p:cNvSpPr/>
            <p:nvPr/>
          </p:nvSpPr>
          <p:spPr>
            <a:xfrm flipH="1">
              <a:off x="14025600" y="16795800"/>
              <a:ext cx="1440" cy="214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Straight Connector 386"/>
            <p:cNvSpPr/>
            <p:nvPr/>
          </p:nvSpPr>
          <p:spPr>
            <a:xfrm flipH="1">
              <a:off x="14162040" y="16795800"/>
              <a:ext cx="1440" cy="2142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TextBox 457"/>
            <p:cNvSpPr/>
            <p:nvPr/>
          </p:nvSpPr>
          <p:spPr>
            <a:xfrm>
              <a:off x="14590440" y="16134840"/>
              <a:ext cx="47390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mindanensis </a:t>
              </a: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Mindanao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Oval 388"/>
            <p:cNvSpPr/>
            <p:nvPr/>
          </p:nvSpPr>
          <p:spPr>
            <a:xfrm>
              <a:off x="13623840" y="16754400"/>
              <a:ext cx="276120" cy="277560"/>
            </a:xfrm>
            <a:prstGeom prst="ellipse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Oval 389"/>
            <p:cNvSpPr/>
            <p:nvPr/>
          </p:nvSpPr>
          <p:spPr>
            <a:xfrm>
              <a:off x="13625640" y="17145000"/>
              <a:ext cx="277560" cy="277560"/>
            </a:xfrm>
            <a:prstGeom prst="ellipse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Oval 390"/>
            <p:cNvSpPr/>
            <p:nvPr/>
          </p:nvSpPr>
          <p:spPr>
            <a:xfrm>
              <a:off x="12841200" y="16743240"/>
              <a:ext cx="276120" cy="277560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Oval 391"/>
            <p:cNvSpPr/>
            <p:nvPr/>
          </p:nvSpPr>
          <p:spPr>
            <a:xfrm>
              <a:off x="13220640" y="16749720"/>
              <a:ext cx="277560" cy="276120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Oval 392"/>
            <p:cNvSpPr/>
            <p:nvPr/>
          </p:nvSpPr>
          <p:spPr>
            <a:xfrm>
              <a:off x="14285880" y="16865640"/>
              <a:ext cx="68040" cy="666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endParaRPr b="0" lang="en-US" sz="5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TextBox 457"/>
            <p:cNvSpPr/>
            <p:nvPr/>
          </p:nvSpPr>
          <p:spPr>
            <a:xfrm>
              <a:off x="12745800" y="17422560"/>
              <a:ext cx="2745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deuteronymu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TextBox 457"/>
            <p:cNvSpPr/>
            <p:nvPr/>
          </p:nvSpPr>
          <p:spPr>
            <a:xfrm>
              <a:off x="11125800" y="16123320"/>
              <a:ext cx="2466720" cy="119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3600" spc="-1" strike="noStrike">
                  <a:solidFill>
                    <a:srgbClr val="000000"/>
                  </a:solidFill>
                  <a:latin typeface="Times New Roman"/>
                </a:rPr>
                <a:t>mindanensis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lang="en-US" sz="3600" spc="-1" strike="noStrike">
                  <a:solidFill>
                    <a:srgbClr val="000000"/>
                  </a:solidFill>
                  <a:latin typeface="Times New Roman"/>
                </a:rPr>
                <a:t>(Cebu)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TextBox 1103"/>
            <p:cNvSpPr/>
            <p:nvPr/>
          </p:nvSpPr>
          <p:spPr>
            <a:xfrm>
              <a:off x="10933200" y="14847840"/>
              <a:ext cx="9815400" cy="106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371600"/>
                  <a:tab algn="l" pos="2743200"/>
                  <a:tab algn="l" pos="4114800"/>
                  <a:tab algn="l" pos="5486400"/>
                  <a:tab algn="l" pos="6858000"/>
                  <a:tab algn="l" pos="8229600"/>
                  <a:tab algn="l" pos="9601200"/>
                </a:tabLst>
              </a:pPr>
              <a:r>
                <a:rPr b="0" i="1" lang="en-US" sz="6400" spc="-1" strike="noStrike">
                  <a:solidFill>
                    <a:srgbClr val="000000"/>
                  </a:solidFill>
                  <a:latin typeface="Times New Roman"/>
                </a:rPr>
                <a:t>Copsychus mindanensis</a:t>
              </a:r>
              <a:endParaRPr b="0" lang="en-US" sz="6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4" name="Oval 396"/>
          <p:cNvSpPr/>
          <p:nvPr/>
        </p:nvSpPr>
        <p:spPr>
          <a:xfrm>
            <a:off x="1295280" y="12442680"/>
            <a:ext cx="279360" cy="279720"/>
          </a:xfrm>
          <a:prstGeom prst="ellipse">
            <a:avLst/>
          </a:prstGeom>
          <a:solidFill>
            <a:srgbClr val="00304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TextBox 454"/>
          <p:cNvSpPr/>
          <p:nvPr/>
        </p:nvSpPr>
        <p:spPr>
          <a:xfrm>
            <a:off x="1663560" y="12231720"/>
            <a:ext cx="157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i="1" lang="en-US" sz="3600" spc="-1" strike="noStrike">
                <a:solidFill>
                  <a:srgbClr val="000000"/>
                </a:solidFill>
                <a:latin typeface="Times New Roman"/>
              </a:rPr>
              <a:t>elegan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TextBox 456"/>
          <p:cNvSpPr/>
          <p:nvPr/>
        </p:nvSpPr>
        <p:spPr>
          <a:xfrm>
            <a:off x="6421320" y="9442440"/>
            <a:ext cx="3389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i="1" lang="en-US" sz="3600" spc="-1" strike="noStrike">
                <a:solidFill>
                  <a:srgbClr val="000000"/>
                </a:solidFill>
                <a:latin typeface="Times New Roman"/>
              </a:rPr>
              <a:t>albescen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TextBox 442"/>
          <p:cNvSpPr/>
          <p:nvPr/>
        </p:nvSpPr>
        <p:spPr>
          <a:xfrm>
            <a:off x="715680" y="1341360"/>
            <a:ext cx="6453360" cy="106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Times New Roman"/>
              </a:rPr>
              <a:t>Figure A in S2 File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8" name="Picture 5" descr=""/>
          <p:cNvPicPr/>
          <p:nvPr/>
        </p:nvPicPr>
        <p:blipFill>
          <a:blip r:embed="rId1"/>
          <a:stretch/>
        </p:blipFill>
        <p:spPr>
          <a:xfrm>
            <a:off x="326880" y="3668760"/>
            <a:ext cx="19366200" cy="19365840"/>
          </a:xfrm>
          <a:prstGeom prst="rect">
            <a:avLst/>
          </a:prstGeom>
          <a:ln w="0">
            <a:noFill/>
          </a:ln>
        </p:spPr>
      </p:pic>
      <p:sp>
        <p:nvSpPr>
          <p:cNvPr id="439" name="TextBox 442"/>
          <p:cNvSpPr/>
          <p:nvPr/>
        </p:nvSpPr>
        <p:spPr>
          <a:xfrm>
            <a:off x="760680" y="1341360"/>
            <a:ext cx="6409440" cy="106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371600"/>
                <a:tab algn="l" pos="2743200"/>
                <a:tab algn="l" pos="4114800"/>
                <a:tab algn="l" pos="5486400"/>
                <a:tab algn="l" pos="6858000"/>
                <a:tab algn="l" pos="8229600"/>
                <a:tab algn="l" pos="96012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Times New Roman"/>
              </a:rPr>
              <a:t>Figure B in S2 File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17T07:26:08Z</dcterms:created>
  <dc:creator>Kyle Campbell</dc:creator>
  <dc:description/>
  <dc:language>en-US</dc:language>
  <cp:lastModifiedBy> Anonymous</cp:lastModifiedBy>
  <cp:lastPrinted>2015-11-17T08:01:36Z</cp:lastPrinted>
  <dcterms:modified xsi:type="dcterms:W3CDTF">2016-07-06T23:02:58Z</dcterms:modified>
  <cp:revision>10</cp:revision>
  <dc:subject/>
  <dc:title>PowerPoint Presentation</dc:title>
</cp:coreProperties>
</file>